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9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DC" initials="CDC" lastIdx="1" clrIdx="0">
    <p:extLst>
      <p:ext uri="{19B8F6BF-5375-455C-9EA6-DF929625EA0E}">
        <p15:presenceInfo xmlns:p15="http://schemas.microsoft.com/office/powerpoint/2012/main" userId="CD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03C8126-1AE1-4CB3-9E1D-30F35E6FB32F}" v="2" dt="2022-02-24T20:28:24.8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84" y="3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vorkova, Elena" userId="667dcd78-d6a5-4e32-a662-6d050269f6e2" providerId="ADAL" clId="{403C8126-1AE1-4CB3-9E1D-30F35E6FB32F}"/>
    <pc:docChg chg="undo redo custSel modSld">
      <pc:chgData name="Govorkova, Elena" userId="667dcd78-d6a5-4e32-a662-6d050269f6e2" providerId="ADAL" clId="{403C8126-1AE1-4CB3-9E1D-30F35E6FB32F}" dt="2022-02-24T20:35:05.533" v="160" actId="692"/>
      <pc:docMkLst>
        <pc:docMk/>
      </pc:docMkLst>
      <pc:sldChg chg="addSp delSp modSp mod">
        <pc:chgData name="Govorkova, Elena" userId="667dcd78-d6a5-4e32-a662-6d050269f6e2" providerId="ADAL" clId="{403C8126-1AE1-4CB3-9E1D-30F35E6FB32F}" dt="2022-02-24T20:35:05.533" v="160" actId="692"/>
        <pc:sldMkLst>
          <pc:docMk/>
          <pc:sldMk cId="3311727511" sldId="288"/>
        </pc:sldMkLst>
        <pc:spChg chg="add del mod">
          <ac:chgData name="Govorkova, Elena" userId="667dcd78-d6a5-4e32-a662-6d050269f6e2" providerId="ADAL" clId="{403C8126-1AE1-4CB3-9E1D-30F35E6FB32F}" dt="2022-02-24T20:28:24.815" v="73" actId="767"/>
          <ac:spMkLst>
            <pc:docMk/>
            <pc:sldMk cId="3311727511" sldId="288"/>
            <ac:spMk id="5" creationId="{C59928FB-388B-455A-8D65-1BAD6830871B}"/>
          </ac:spMkLst>
        </pc:spChg>
        <pc:spChg chg="mod">
          <ac:chgData name="Govorkova, Elena" userId="667dcd78-d6a5-4e32-a662-6d050269f6e2" providerId="ADAL" clId="{403C8126-1AE1-4CB3-9E1D-30F35E6FB32F}" dt="2022-02-24T20:29:09.078" v="76" actId="1076"/>
          <ac:spMkLst>
            <pc:docMk/>
            <pc:sldMk cId="3311727511" sldId="288"/>
            <ac:spMk id="10" creationId="{B1C92DF9-0F49-4861-99C4-A9453B3E3C12}"/>
          </ac:spMkLst>
        </pc:spChg>
        <pc:spChg chg="mod">
          <ac:chgData name="Govorkova, Elena" userId="667dcd78-d6a5-4e32-a662-6d050269f6e2" providerId="ADAL" clId="{403C8126-1AE1-4CB3-9E1D-30F35E6FB32F}" dt="2022-02-24T20:31:03.214" v="88" actId="14100"/>
          <ac:spMkLst>
            <pc:docMk/>
            <pc:sldMk cId="3311727511" sldId="288"/>
            <ac:spMk id="32" creationId="{B7A8193E-0132-4D16-B236-A47858799327}"/>
          </ac:spMkLst>
        </pc:spChg>
        <pc:spChg chg="mod">
          <ac:chgData name="Govorkova, Elena" userId="667dcd78-d6a5-4e32-a662-6d050269f6e2" providerId="ADAL" clId="{403C8126-1AE1-4CB3-9E1D-30F35E6FB32F}" dt="2022-02-24T20:28:12.507" v="67" actId="21"/>
          <ac:spMkLst>
            <pc:docMk/>
            <pc:sldMk cId="3311727511" sldId="288"/>
            <ac:spMk id="39" creationId="{EDBDA644-D249-4D91-B497-070836DE1590}"/>
          </ac:spMkLst>
        </pc:spChg>
        <pc:spChg chg="mod">
          <ac:chgData name="Govorkova, Elena" userId="667dcd78-d6a5-4e32-a662-6d050269f6e2" providerId="ADAL" clId="{403C8126-1AE1-4CB3-9E1D-30F35E6FB32F}" dt="2022-02-24T20:31:05.313" v="91" actId="255"/>
          <ac:spMkLst>
            <pc:docMk/>
            <pc:sldMk cId="3311727511" sldId="288"/>
            <ac:spMk id="44" creationId="{90BA1FA0-A1BA-4575-8D9C-681845EF6E81}"/>
          </ac:spMkLst>
        </pc:spChg>
        <pc:spChg chg="add del">
          <ac:chgData name="Govorkova, Elena" userId="667dcd78-d6a5-4e32-a662-6d050269f6e2" providerId="ADAL" clId="{403C8126-1AE1-4CB3-9E1D-30F35E6FB32F}" dt="2022-02-24T20:27:00.489" v="45" actId="22"/>
          <ac:spMkLst>
            <pc:docMk/>
            <pc:sldMk cId="3311727511" sldId="288"/>
            <ac:spMk id="45" creationId="{34947CE9-049D-4583-8962-9A52D465F4B5}"/>
          </ac:spMkLst>
        </pc:spChg>
        <pc:spChg chg="mod">
          <ac:chgData name="Govorkova, Elena" userId="667dcd78-d6a5-4e32-a662-6d050269f6e2" providerId="ADAL" clId="{403C8126-1AE1-4CB3-9E1D-30F35E6FB32F}" dt="2022-02-24T20:30:04.400" v="83" actId="255"/>
          <ac:spMkLst>
            <pc:docMk/>
            <pc:sldMk cId="3311727511" sldId="288"/>
            <ac:spMk id="46" creationId="{936D7A9B-D9D5-40B9-B149-812450694935}"/>
          </ac:spMkLst>
        </pc:spChg>
        <pc:spChg chg="add del">
          <ac:chgData name="Govorkova, Elena" userId="667dcd78-d6a5-4e32-a662-6d050269f6e2" providerId="ADAL" clId="{403C8126-1AE1-4CB3-9E1D-30F35E6FB32F}" dt="2022-02-24T20:27:03.835" v="47" actId="22"/>
          <ac:spMkLst>
            <pc:docMk/>
            <pc:sldMk cId="3311727511" sldId="288"/>
            <ac:spMk id="47" creationId="{B67BD037-218B-4C9F-A18F-33933F21CE0F}"/>
          </ac:spMkLst>
        </pc:spChg>
        <pc:spChg chg="add del">
          <ac:chgData name="Govorkova, Elena" userId="667dcd78-d6a5-4e32-a662-6d050269f6e2" providerId="ADAL" clId="{403C8126-1AE1-4CB3-9E1D-30F35E6FB32F}" dt="2022-02-24T20:27:06.742" v="49" actId="22"/>
          <ac:spMkLst>
            <pc:docMk/>
            <pc:sldMk cId="3311727511" sldId="288"/>
            <ac:spMk id="48" creationId="{DD0A41E5-1DFB-4E96-837A-B6E390B3A86B}"/>
          </ac:spMkLst>
        </pc:spChg>
        <pc:spChg chg="add del">
          <ac:chgData name="Govorkova, Elena" userId="667dcd78-d6a5-4e32-a662-6d050269f6e2" providerId="ADAL" clId="{403C8126-1AE1-4CB3-9E1D-30F35E6FB32F}" dt="2022-02-24T20:27:17.414" v="51" actId="22"/>
          <ac:spMkLst>
            <pc:docMk/>
            <pc:sldMk cId="3311727511" sldId="288"/>
            <ac:spMk id="49" creationId="{04156008-4C29-4813-BB01-39BF2E5C51DD}"/>
          </ac:spMkLst>
        </pc:spChg>
        <pc:spChg chg="add del">
          <ac:chgData name="Govorkova, Elena" userId="667dcd78-d6a5-4e32-a662-6d050269f6e2" providerId="ADAL" clId="{403C8126-1AE1-4CB3-9E1D-30F35E6FB32F}" dt="2022-02-24T20:27:20.991" v="53" actId="22"/>
          <ac:spMkLst>
            <pc:docMk/>
            <pc:sldMk cId="3311727511" sldId="288"/>
            <ac:spMk id="51" creationId="{A1CEB3A8-C60C-4F16-8752-B70E1FDE62B2}"/>
          </ac:spMkLst>
        </pc:spChg>
        <pc:spChg chg="add del">
          <ac:chgData name="Govorkova, Elena" userId="667dcd78-d6a5-4e32-a662-6d050269f6e2" providerId="ADAL" clId="{403C8126-1AE1-4CB3-9E1D-30F35E6FB32F}" dt="2022-02-24T20:27:25.338" v="55" actId="22"/>
          <ac:spMkLst>
            <pc:docMk/>
            <pc:sldMk cId="3311727511" sldId="288"/>
            <ac:spMk id="52" creationId="{B3E6BB8E-E307-48C3-AFDC-8EDF30EAC8D5}"/>
          </ac:spMkLst>
        </pc:spChg>
        <pc:spChg chg="add del">
          <ac:chgData name="Govorkova, Elena" userId="667dcd78-d6a5-4e32-a662-6d050269f6e2" providerId="ADAL" clId="{403C8126-1AE1-4CB3-9E1D-30F35E6FB32F}" dt="2022-02-24T20:27:51.931" v="57" actId="22"/>
          <ac:spMkLst>
            <pc:docMk/>
            <pc:sldMk cId="3311727511" sldId="288"/>
            <ac:spMk id="53" creationId="{692E0D09-72EB-409C-A94D-E2D0627EB5AE}"/>
          </ac:spMkLst>
        </pc:spChg>
        <pc:spChg chg="mod">
          <ac:chgData name="Govorkova, Elena" userId="667dcd78-d6a5-4e32-a662-6d050269f6e2" providerId="ADAL" clId="{403C8126-1AE1-4CB3-9E1D-30F35E6FB32F}" dt="2022-02-24T20:28:15.954" v="69" actId="1076"/>
          <ac:spMkLst>
            <pc:docMk/>
            <pc:sldMk cId="3311727511" sldId="288"/>
            <ac:spMk id="69" creationId="{14F28E5E-8624-4210-8BAD-D6E7A77ABFE7}"/>
          </ac:spMkLst>
        </pc:spChg>
        <pc:spChg chg="mod">
          <ac:chgData name="Govorkova, Elena" userId="667dcd78-d6a5-4e32-a662-6d050269f6e2" providerId="ADAL" clId="{403C8126-1AE1-4CB3-9E1D-30F35E6FB32F}" dt="2022-02-24T20:28:14.919" v="68" actId="1076"/>
          <ac:spMkLst>
            <pc:docMk/>
            <pc:sldMk cId="3311727511" sldId="288"/>
            <ac:spMk id="70" creationId="{152F0C61-C777-478F-96B0-5F6926D6D37E}"/>
          </ac:spMkLst>
        </pc:spChg>
        <pc:spChg chg="mod">
          <ac:chgData name="Govorkova, Elena" userId="667dcd78-d6a5-4e32-a662-6d050269f6e2" providerId="ADAL" clId="{403C8126-1AE1-4CB3-9E1D-30F35E6FB32F}" dt="2022-02-24T20:35:05.533" v="160" actId="692"/>
          <ac:spMkLst>
            <pc:docMk/>
            <pc:sldMk cId="3311727511" sldId="288"/>
            <ac:spMk id="72" creationId="{8523F57B-62BB-4243-9D86-9C3D69814FF5}"/>
          </ac:spMkLst>
        </pc:spChg>
        <pc:spChg chg="mod">
          <ac:chgData name="Govorkova, Elena" userId="667dcd78-d6a5-4e32-a662-6d050269f6e2" providerId="ADAL" clId="{403C8126-1AE1-4CB3-9E1D-30F35E6FB32F}" dt="2022-02-24T20:29:51.851" v="82" actId="255"/>
          <ac:spMkLst>
            <pc:docMk/>
            <pc:sldMk cId="3311727511" sldId="288"/>
            <ac:spMk id="74" creationId="{72D68181-E5B9-4A12-88E1-CD2E553DD777}"/>
          </ac:spMkLst>
        </pc:spChg>
        <pc:spChg chg="mod">
          <ac:chgData name="Govorkova, Elena" userId="667dcd78-d6a5-4e32-a662-6d050269f6e2" providerId="ADAL" clId="{403C8126-1AE1-4CB3-9E1D-30F35E6FB32F}" dt="2022-02-24T20:34:55.803" v="154" actId="692"/>
          <ac:spMkLst>
            <pc:docMk/>
            <pc:sldMk cId="3311727511" sldId="288"/>
            <ac:spMk id="79" creationId="{337DE74F-00E4-4414-AF95-A3BE1C67F343}"/>
          </ac:spMkLst>
        </pc:spChg>
        <pc:spChg chg="mod">
          <ac:chgData name="Govorkova, Elena" userId="667dcd78-d6a5-4e32-a662-6d050269f6e2" providerId="ADAL" clId="{403C8126-1AE1-4CB3-9E1D-30F35E6FB32F}" dt="2022-02-24T20:28:01.334" v="62" actId="1076"/>
          <ac:spMkLst>
            <pc:docMk/>
            <pc:sldMk cId="3311727511" sldId="288"/>
            <ac:spMk id="83" creationId="{096298BB-21BA-421B-A0E3-C609479CB7E3}"/>
          </ac:spMkLst>
        </pc:spChg>
        <pc:grpChg chg="add del mod">
          <ac:chgData name="Govorkova, Elena" userId="667dcd78-d6a5-4e32-a662-6d050269f6e2" providerId="ADAL" clId="{403C8126-1AE1-4CB3-9E1D-30F35E6FB32F}" dt="2022-02-24T20:28:25.548" v="74" actId="14100"/>
          <ac:grpSpMkLst>
            <pc:docMk/>
            <pc:sldMk cId="3311727511" sldId="288"/>
            <ac:grpSpMk id="4" creationId="{A32B3941-7410-4C79-BF07-8ACF0E7BE0F2}"/>
          </ac:grpSpMkLst>
        </pc:grpChg>
        <pc:cxnChg chg="mod">
          <ac:chgData name="Govorkova, Elena" userId="667dcd78-d6a5-4e32-a662-6d050269f6e2" providerId="ADAL" clId="{403C8126-1AE1-4CB3-9E1D-30F35E6FB32F}" dt="2022-02-24T20:27:53.088" v="58" actId="478"/>
          <ac:cxnSpMkLst>
            <pc:docMk/>
            <pc:sldMk cId="3311727511" sldId="288"/>
            <ac:cxnSpMk id="6" creationId="{13CCDDFF-C1E5-41CC-AD47-C010AECEE0B3}"/>
          </ac:cxnSpMkLst>
        </pc:cxnChg>
        <pc:cxnChg chg="mod">
          <ac:chgData name="Govorkova, Elena" userId="667dcd78-d6a5-4e32-a662-6d050269f6e2" providerId="ADAL" clId="{403C8126-1AE1-4CB3-9E1D-30F35E6FB32F}" dt="2022-02-24T20:29:51.851" v="82" actId="255"/>
          <ac:cxnSpMkLst>
            <pc:docMk/>
            <pc:sldMk cId="3311727511" sldId="288"/>
            <ac:cxnSpMk id="20" creationId="{90398FD7-A0ED-40A1-8E44-29FF2539F59F}"/>
          </ac:cxnSpMkLst>
        </pc:cxnChg>
        <pc:cxnChg chg="mod">
          <ac:chgData name="Govorkova, Elena" userId="667dcd78-d6a5-4e32-a662-6d050269f6e2" providerId="ADAL" clId="{403C8126-1AE1-4CB3-9E1D-30F35E6FB32F}" dt="2022-02-24T20:27:53.088" v="58" actId="478"/>
          <ac:cxnSpMkLst>
            <pc:docMk/>
            <pc:sldMk cId="3311727511" sldId="288"/>
            <ac:cxnSpMk id="36" creationId="{B2D8933A-A8C4-40E6-AA09-6AE36D26CC52}"/>
          </ac:cxnSpMkLst>
        </pc:cxnChg>
      </pc:sldChg>
      <pc:sldChg chg="modSp mod">
        <pc:chgData name="Govorkova, Elena" userId="667dcd78-d6a5-4e32-a662-6d050269f6e2" providerId="ADAL" clId="{403C8126-1AE1-4CB3-9E1D-30F35E6FB32F}" dt="2022-02-24T20:34:18.670" v="148" actId="20577"/>
        <pc:sldMkLst>
          <pc:docMk/>
          <pc:sldMk cId="2212975789" sldId="290"/>
        </pc:sldMkLst>
        <pc:spChg chg="mod">
          <ac:chgData name="Govorkova, Elena" userId="667dcd78-d6a5-4e32-a662-6d050269f6e2" providerId="ADAL" clId="{403C8126-1AE1-4CB3-9E1D-30F35E6FB32F}" dt="2022-02-24T20:34:18.670" v="148" actId="20577"/>
          <ac:spMkLst>
            <pc:docMk/>
            <pc:sldMk cId="2212975789" sldId="290"/>
            <ac:spMk id="39" creationId="{EDBDA644-D249-4D91-B497-070836DE1590}"/>
          </ac:spMkLst>
        </pc:spChg>
        <pc:spChg chg="mod">
          <ac:chgData name="Govorkova, Elena" userId="667dcd78-d6a5-4e32-a662-6d050269f6e2" providerId="ADAL" clId="{403C8126-1AE1-4CB3-9E1D-30F35E6FB32F}" dt="2022-02-24T20:33:55.896" v="117" actId="692"/>
          <ac:spMkLst>
            <pc:docMk/>
            <pc:sldMk cId="2212975789" sldId="290"/>
            <ac:spMk id="72" creationId="{8523F57B-62BB-4243-9D86-9C3D69814FF5}"/>
          </ac:spMkLst>
        </pc:spChg>
        <pc:spChg chg="mod">
          <ac:chgData name="Govorkova, Elena" userId="667dcd78-d6a5-4e32-a662-6d050269f6e2" providerId="ADAL" clId="{403C8126-1AE1-4CB3-9E1D-30F35E6FB32F}" dt="2022-02-24T20:33:28.220" v="109" actId="692"/>
          <ac:spMkLst>
            <pc:docMk/>
            <pc:sldMk cId="2212975789" sldId="290"/>
            <ac:spMk id="74" creationId="{72D68181-E5B9-4A12-88E1-CD2E553DD777}"/>
          </ac:spMkLst>
        </pc:spChg>
        <pc:spChg chg="mod">
          <ac:chgData name="Govorkova, Elena" userId="667dcd78-d6a5-4e32-a662-6d050269f6e2" providerId="ADAL" clId="{403C8126-1AE1-4CB3-9E1D-30F35E6FB32F}" dt="2022-02-24T20:33:32.768" v="111" actId="692"/>
          <ac:spMkLst>
            <pc:docMk/>
            <pc:sldMk cId="2212975789" sldId="290"/>
            <ac:spMk id="79" creationId="{337DE74F-00E4-4414-AF95-A3BE1C67F343}"/>
          </ac:spMkLst>
        </pc:spChg>
        <pc:grpChg chg="mod">
          <ac:chgData name="Govorkova, Elena" userId="667dcd78-d6a5-4e32-a662-6d050269f6e2" providerId="ADAL" clId="{403C8126-1AE1-4CB3-9E1D-30F35E6FB32F}" dt="2022-02-24T20:24:09.775" v="33" actId="1076"/>
          <ac:grpSpMkLst>
            <pc:docMk/>
            <pc:sldMk cId="2212975789" sldId="290"/>
            <ac:grpSpMk id="4" creationId="{9C0B7C72-4C20-4BB9-9368-7FF9DE6E3940}"/>
          </ac:grpSpMkLst>
        </pc:grpChg>
        <pc:cxnChg chg="mod">
          <ac:chgData name="Govorkova, Elena" userId="667dcd78-d6a5-4e32-a662-6d050269f6e2" providerId="ADAL" clId="{403C8126-1AE1-4CB3-9E1D-30F35E6FB32F}" dt="2022-02-24T20:33:26.999" v="107" actId="6549"/>
          <ac:cxnSpMkLst>
            <pc:docMk/>
            <pc:sldMk cId="2212975789" sldId="290"/>
            <ac:cxnSpMk id="20" creationId="{90398FD7-A0ED-40A1-8E44-29FF2539F59F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C7A43-FA5A-465C-9BD9-FB5A486C3B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D22DAF-6B3E-402B-9095-44441326D3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B1334-981E-4715-A4A6-929696E57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0E9502-34B9-442E-B9F1-1F16E53EA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2785C4-C83A-4591-979D-B77084AB7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032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F613F-9F44-4FAE-BF6A-3E8842E0DC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46793A-4F9D-4674-B717-FEAEFDBD88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64FA2-0CC2-4616-A916-2BB3763F6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1FA0A3-414A-49AD-A38D-5965B5709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E1888-6E89-4141-875A-4C5AE3933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185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1E9AAE-94BE-4D8C-913B-2C4025A0C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33F07F-BAFD-45EF-B400-D542535501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DB208-091C-4CFC-AABB-EBD622ABE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E690A3-7C7A-4F2F-B537-CC7C3C501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078A00-2926-4C75-9259-869C48F7F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633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688C9F-40C9-4A73-B2BB-6BA0AD634A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268B0-9E72-410B-A101-207367CC3A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5A854-C375-4A89-BC95-22458B452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5C1D41-CE8A-4E1E-A0A8-1E5A23275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D6E631-7321-4E68-8F1A-3B731BB6F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895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E26EF6-1D2F-4628-8634-52C38AAB8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1C2904-E0F8-40A3-BF74-40DF09DE9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CD7FA-27B8-4A82-959D-32999D3D2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6D2588-3FEC-404E-9088-7BC11ED89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113B1-775A-4FA9-9F4B-48357CD6F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1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53177-EDD7-440F-831C-8CE6280965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C222C3-49B2-4C08-841E-4C93E18D60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70C6C5-8C6B-4AB8-BF59-1E9CF9EF10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7334C4-0C70-4A4C-9520-D2810E598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E918E1-84C4-4ABF-93C5-AE535D9FB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D8D190-313F-47FF-84D7-96C85929F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096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818CA8-0E55-4805-AD84-1ACDC97157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752489-8D34-4625-A817-598D1B62A0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59926B-8D2B-4A5B-BDCC-4F78E88D4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859BC7-C25F-4779-AEA0-F84D0794B7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E1FDA1-F11A-478F-8AE9-6B8CBA27BE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3A1D97-5C54-499E-B899-6698368A0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E0F1CC-8F88-4E30-A5DF-47641564C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34C132-2849-4A15-BA46-2A7A090A2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79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21A972-4605-4B25-A456-3D745C915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BBB2A6-4BC6-4125-A34E-8C3242C46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46C3A3-A7C3-435F-A06E-5B63E6AFD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F65585-B81D-48B2-9F6E-02EE421DA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19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6A36E4-8282-4515-BB6E-1D7ECFB81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F80D14-0D42-425C-AB9F-1FA20C8C2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B769629-BC4C-480F-B719-9E08875E0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54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F4CD0-0EEF-487C-9FDE-E7345F960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10654E-A2ED-49B2-BA62-02D4009569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CF50E7-F33D-424F-9393-611C4D46A1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72C0C-F4E6-4F57-B808-56D44F5A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C9BC1E-7F61-4409-9CB5-AE139EAB3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801148-61A0-44EC-9E43-816240F77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961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C789F-50F1-4C27-9B80-C2357C979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3EF864-3DBC-47AF-A439-3ECB6F258D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7D41B3-7BF0-425B-A01B-42F488D396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4111FD-26C6-483E-936B-16DE4AD81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B74B96-4953-4C5B-AC1A-041D581B2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DC41D6-E929-4A75-98FF-3A924C18D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358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1A665E-7E83-4001-9940-802BCEE9F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6B6722-D354-4469-ADB4-CF4CBC044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D05795-EF0E-4D6A-9862-443F6E55EE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F8932F-E750-4E9F-98A5-5CB50C970C1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38B1B2-9DFF-4D33-8DB4-5BD2191D24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2C5DAE-FFE9-4149-B7BF-703085469E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F84B5-4E07-4F8E-A93A-71619F122A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176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itle 1">
            <a:extLst>
              <a:ext uri="{FF2B5EF4-FFF2-40B4-BE49-F238E27FC236}">
                <a16:creationId xmlns:a16="http://schemas.microsoft.com/office/drawing/2014/main" id="{EDBDA644-D249-4D91-B497-070836DE1590}"/>
              </a:ext>
            </a:extLst>
          </p:cNvPr>
          <p:cNvSpPr txBox="1">
            <a:spLocks/>
          </p:cNvSpPr>
          <p:nvPr/>
        </p:nvSpPr>
        <p:spPr>
          <a:xfrm>
            <a:off x="408288" y="198571"/>
            <a:ext cx="11464603" cy="46779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b="1" dirty="0">
                <a:solidFill>
                  <a:schemeClr val="accent1">
                    <a:lumMod val="75000"/>
                  </a:schemeClr>
                </a:solidFill>
              </a:rPr>
              <a:t>Fig S1. NAI susceptibility data analysis flowchart: 2018-2019 period</a:t>
            </a:r>
          </a:p>
        </p:txBody>
      </p:sp>
      <p:sp>
        <p:nvSpPr>
          <p:cNvPr id="61" name="Slide Number Placeholder 7">
            <a:extLst>
              <a:ext uri="{FF2B5EF4-FFF2-40B4-BE49-F238E27FC236}">
                <a16:creationId xmlns:a16="http://schemas.microsoft.com/office/drawing/2014/main" id="{75A99F03-5D0D-4BA1-BF09-EA5B661E35DA}"/>
              </a:ext>
            </a:extLst>
          </p:cNvPr>
          <p:cNvSpPr txBox="1">
            <a:spLocks/>
          </p:cNvSpPr>
          <p:nvPr/>
        </p:nvSpPr>
        <p:spPr>
          <a:xfrm>
            <a:off x="9045276" y="257231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32F5A1F4-4370-4CBB-A432-5A4DC939E9C2}" type="slidenum">
              <a:rPr lang="en-US" smtClean="0"/>
              <a:pPr/>
              <a:t>1</a:t>
            </a:fld>
            <a:endParaRPr lang="en-US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32B3941-7410-4C79-BF07-8ACF0E7BE0F2}"/>
              </a:ext>
            </a:extLst>
          </p:cNvPr>
          <p:cNvGrpSpPr/>
          <p:nvPr/>
        </p:nvGrpSpPr>
        <p:grpSpPr>
          <a:xfrm>
            <a:off x="1170903" y="933545"/>
            <a:ext cx="9884734" cy="5189810"/>
            <a:chOff x="582434" y="1024075"/>
            <a:chExt cx="9884734" cy="5189810"/>
          </a:xfrm>
        </p:grpSpPr>
        <p:cxnSp>
          <p:nvCxnSpPr>
            <p:cNvPr id="20" name="Connector: Curved 19">
              <a:extLst>
                <a:ext uri="{FF2B5EF4-FFF2-40B4-BE49-F238E27FC236}">
                  <a16:creationId xmlns:a16="http://schemas.microsoft.com/office/drawing/2014/main" id="{90398FD7-A0ED-40A1-8E44-29FF2539F59F}"/>
                </a:ext>
              </a:extLst>
            </p:cNvPr>
            <p:cNvCxnSpPr>
              <a:cxnSpLocks/>
              <a:stCxn id="74" idx="3"/>
              <a:endCxn id="50" idx="0"/>
            </p:cNvCxnSpPr>
            <p:nvPr/>
          </p:nvCxnSpPr>
          <p:spPr>
            <a:xfrm flipH="1">
              <a:off x="9446088" y="1792238"/>
              <a:ext cx="399343" cy="1127498"/>
            </a:xfrm>
            <a:prstGeom prst="curvedConnector4">
              <a:avLst>
                <a:gd name="adj1" fmla="val -57244"/>
                <a:gd name="adj2" fmla="val 74568"/>
              </a:avLst>
            </a:prstGeom>
            <a:ln w="38100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or: Curved 55">
              <a:extLst>
                <a:ext uri="{FF2B5EF4-FFF2-40B4-BE49-F238E27FC236}">
                  <a16:creationId xmlns:a16="http://schemas.microsoft.com/office/drawing/2014/main" id="{AB7DE794-B312-4B93-99DF-87AFB901812C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8070930" y="4244714"/>
              <a:ext cx="1218901" cy="829069"/>
            </a:xfrm>
            <a:prstGeom prst="curvedConnector3">
              <a:avLst>
                <a:gd name="adj1" fmla="val 503"/>
              </a:avLst>
            </a:prstGeom>
            <a:ln w="38100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Arrow: Right 66">
              <a:extLst>
                <a:ext uri="{FF2B5EF4-FFF2-40B4-BE49-F238E27FC236}">
                  <a16:creationId xmlns:a16="http://schemas.microsoft.com/office/drawing/2014/main" id="{CAA1ECF0-170F-455E-A667-52D9ABF59F13}"/>
                </a:ext>
              </a:extLst>
            </p:cNvPr>
            <p:cNvSpPr/>
            <p:nvPr/>
          </p:nvSpPr>
          <p:spPr>
            <a:xfrm>
              <a:off x="7323160" y="1542550"/>
              <a:ext cx="869692" cy="299567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object 5">
              <a:extLst>
                <a:ext uri="{FF2B5EF4-FFF2-40B4-BE49-F238E27FC236}">
                  <a16:creationId xmlns:a16="http://schemas.microsoft.com/office/drawing/2014/main" id="{337DE74F-00E4-4414-AF95-A3BE1C67F343}"/>
                </a:ext>
              </a:extLst>
            </p:cNvPr>
            <p:cNvSpPr/>
            <p:nvPr/>
          </p:nvSpPr>
          <p:spPr>
            <a:xfrm>
              <a:off x="5847750" y="1024075"/>
              <a:ext cx="1516886" cy="1398958"/>
            </a:xfrm>
            <a:custGeom>
              <a:avLst/>
              <a:gdLst/>
              <a:ahLst/>
              <a:cxnLst/>
              <a:rect l="l" t="t" r="r" b="b"/>
              <a:pathLst>
                <a:path w="1582420" h="1769745">
                  <a:moveTo>
                    <a:pt x="1318260" y="0"/>
                  </a:moveTo>
                  <a:lnTo>
                    <a:pt x="263652" y="0"/>
                  </a:lnTo>
                  <a:lnTo>
                    <a:pt x="216244" y="4245"/>
                  </a:lnTo>
                  <a:lnTo>
                    <a:pt x="171631" y="16488"/>
                  </a:lnTo>
                  <a:lnTo>
                    <a:pt x="130556" y="35983"/>
                  </a:lnTo>
                  <a:lnTo>
                    <a:pt x="93760" y="61988"/>
                  </a:lnTo>
                  <a:lnTo>
                    <a:pt x="61988" y="93760"/>
                  </a:lnTo>
                  <a:lnTo>
                    <a:pt x="35983" y="130556"/>
                  </a:lnTo>
                  <a:lnTo>
                    <a:pt x="16488" y="171631"/>
                  </a:lnTo>
                  <a:lnTo>
                    <a:pt x="4245" y="216244"/>
                  </a:lnTo>
                  <a:lnTo>
                    <a:pt x="0" y="263651"/>
                  </a:lnTo>
                  <a:lnTo>
                    <a:pt x="0" y="1505712"/>
                  </a:lnTo>
                  <a:lnTo>
                    <a:pt x="4245" y="1553119"/>
                  </a:lnTo>
                  <a:lnTo>
                    <a:pt x="16488" y="1597732"/>
                  </a:lnTo>
                  <a:lnTo>
                    <a:pt x="35983" y="1638807"/>
                  </a:lnTo>
                  <a:lnTo>
                    <a:pt x="61988" y="1675603"/>
                  </a:lnTo>
                  <a:lnTo>
                    <a:pt x="93760" y="1707375"/>
                  </a:lnTo>
                  <a:lnTo>
                    <a:pt x="130556" y="1733380"/>
                  </a:lnTo>
                  <a:lnTo>
                    <a:pt x="171631" y="1752875"/>
                  </a:lnTo>
                  <a:lnTo>
                    <a:pt x="216244" y="1765118"/>
                  </a:lnTo>
                  <a:lnTo>
                    <a:pt x="263652" y="1769364"/>
                  </a:lnTo>
                  <a:lnTo>
                    <a:pt x="1318260" y="1769364"/>
                  </a:lnTo>
                  <a:lnTo>
                    <a:pt x="1365667" y="1765118"/>
                  </a:lnTo>
                  <a:lnTo>
                    <a:pt x="1410280" y="1752875"/>
                  </a:lnTo>
                  <a:lnTo>
                    <a:pt x="1451355" y="1733380"/>
                  </a:lnTo>
                  <a:lnTo>
                    <a:pt x="1488151" y="1707375"/>
                  </a:lnTo>
                  <a:lnTo>
                    <a:pt x="1519923" y="1675603"/>
                  </a:lnTo>
                  <a:lnTo>
                    <a:pt x="1545928" y="1638807"/>
                  </a:lnTo>
                  <a:lnTo>
                    <a:pt x="1565423" y="1597732"/>
                  </a:lnTo>
                  <a:lnTo>
                    <a:pt x="1577666" y="1553119"/>
                  </a:lnTo>
                  <a:lnTo>
                    <a:pt x="1581912" y="1505712"/>
                  </a:lnTo>
                  <a:lnTo>
                    <a:pt x="1581912" y="263651"/>
                  </a:lnTo>
                  <a:lnTo>
                    <a:pt x="1577666" y="216244"/>
                  </a:lnTo>
                  <a:lnTo>
                    <a:pt x="1565423" y="171631"/>
                  </a:lnTo>
                  <a:lnTo>
                    <a:pt x="1545928" y="130556"/>
                  </a:lnTo>
                  <a:lnTo>
                    <a:pt x="1519923" y="93760"/>
                  </a:lnTo>
                  <a:lnTo>
                    <a:pt x="1488151" y="61988"/>
                  </a:lnTo>
                  <a:lnTo>
                    <a:pt x="1451356" y="35983"/>
                  </a:lnTo>
                  <a:lnTo>
                    <a:pt x="1410280" y="16488"/>
                  </a:lnTo>
                  <a:lnTo>
                    <a:pt x="1365667" y="4245"/>
                  </a:lnTo>
                  <a:lnTo>
                    <a:pt x="1318260" y="0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5400">
              <a:solidFill>
                <a:schemeClr val="accent2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" name="object 41">
              <a:extLst>
                <a:ext uri="{FF2B5EF4-FFF2-40B4-BE49-F238E27FC236}">
                  <a16:creationId xmlns:a16="http://schemas.microsoft.com/office/drawing/2014/main" id="{E0553CCF-6BC2-4EFF-AF18-69CD9EB7608C}"/>
                </a:ext>
              </a:extLst>
            </p:cNvPr>
            <p:cNvSpPr txBox="1"/>
            <p:nvPr/>
          </p:nvSpPr>
          <p:spPr>
            <a:xfrm>
              <a:off x="3009515" y="1060097"/>
              <a:ext cx="2529035" cy="1741502"/>
            </a:xfrm>
            <a:prstGeom prst="rect">
              <a:avLst/>
            </a:prstGeom>
            <a:ln w="28956">
              <a:solidFill>
                <a:srgbClr val="000000"/>
              </a:solidFill>
            </a:ln>
          </p:spPr>
          <p:txBody>
            <a:bodyPr vert="horz" wrap="square" lIns="0" tIns="147320" rIns="0" bIns="0" rtlCol="0">
              <a:spAutoFit/>
            </a:bodyPr>
            <a:lstStyle/>
            <a:p>
              <a:pPr algn="ctr"/>
              <a:r>
                <a:rPr sz="2000" dirty="0">
                  <a:cs typeface="Calibri"/>
                </a:rPr>
                <a:t>n=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19966 </a:t>
              </a:r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viruses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 </a:t>
              </a:r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analyzed </a:t>
              </a:r>
            </a:p>
            <a:p>
              <a:pPr algn="ctr"/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for NAI susceptibility</a:t>
              </a:r>
            </a:p>
            <a:p>
              <a:pPr algn="ctr">
                <a:spcBef>
                  <a:spcPts val="1160"/>
                </a:spcBef>
              </a:pPr>
              <a:endParaRPr lang="en-US" sz="1850" dirty="0">
                <a:cs typeface="Times New Roman"/>
              </a:endParaRPr>
            </a:p>
            <a:p>
              <a:pPr>
                <a:spcBef>
                  <a:spcPts val="40"/>
                </a:spcBef>
              </a:pPr>
              <a:endParaRPr lang="en-US" sz="1850" dirty="0">
                <a:cs typeface="Times New Roman"/>
              </a:endParaRPr>
            </a:p>
            <a:p>
              <a:pPr>
                <a:spcBef>
                  <a:spcPts val="40"/>
                </a:spcBef>
              </a:pPr>
              <a:endParaRPr sz="1850" dirty="0">
                <a:cs typeface="Times New Roman"/>
              </a:endParaRPr>
            </a:p>
          </p:txBody>
        </p:sp>
        <p:sp>
          <p:nvSpPr>
            <p:cNvPr id="3" name="object 41">
              <a:extLst>
                <a:ext uri="{FF2B5EF4-FFF2-40B4-BE49-F238E27FC236}">
                  <a16:creationId xmlns:a16="http://schemas.microsoft.com/office/drawing/2014/main" id="{BBC288AD-31C5-4CCF-9F68-149A29C64CEC}"/>
                </a:ext>
              </a:extLst>
            </p:cNvPr>
            <p:cNvSpPr txBox="1"/>
            <p:nvPr/>
          </p:nvSpPr>
          <p:spPr>
            <a:xfrm>
              <a:off x="582434" y="2890133"/>
              <a:ext cx="1691548" cy="1287532"/>
            </a:xfrm>
            <a:prstGeom prst="rect">
              <a:avLst/>
            </a:prstGeom>
            <a:ln w="28956">
              <a:solidFill>
                <a:srgbClr val="000000"/>
              </a:solidFill>
            </a:ln>
          </p:spPr>
          <p:txBody>
            <a:bodyPr vert="horz" wrap="square" lIns="0" tIns="147320" rIns="0" bIns="0" rtlCol="0">
              <a:spAutoFit/>
            </a:bodyPr>
            <a:lstStyle/>
            <a:p>
              <a:pPr algn="ctr">
                <a:spcBef>
                  <a:spcPts val="1160"/>
                </a:spcBef>
              </a:pPr>
              <a:r>
                <a:rPr sz="2000" dirty="0">
                  <a:cs typeface="Calibri"/>
                </a:rPr>
                <a:t>n=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 35045</a:t>
              </a:r>
              <a:r>
                <a:rPr lang="en-US" sz="2000" dirty="0"/>
                <a:t> </a:t>
              </a:r>
              <a:endParaRPr sz="2000" dirty="0">
                <a:cs typeface="Calibri"/>
              </a:endParaRPr>
            </a:p>
            <a:p>
              <a:pPr marL="180340" marR="174625" algn="ctr"/>
              <a:r>
                <a:rPr spc="-10" dirty="0">
                  <a:cs typeface="Calibri"/>
                </a:rPr>
                <a:t>Influenza  </a:t>
              </a:r>
              <a:r>
                <a:rPr spc="-5" dirty="0">
                  <a:cs typeface="Calibri"/>
                </a:rPr>
                <a:t>viruses  analyzed</a:t>
              </a:r>
              <a:endParaRPr dirty="0">
                <a:cs typeface="Calibri"/>
              </a:endParaRPr>
            </a:p>
          </p:txBody>
        </p:sp>
        <p:sp>
          <p:nvSpPr>
            <p:cNvPr id="23" name="object 34">
              <a:extLst>
                <a:ext uri="{FF2B5EF4-FFF2-40B4-BE49-F238E27FC236}">
                  <a16:creationId xmlns:a16="http://schemas.microsoft.com/office/drawing/2014/main" id="{0DD8655C-FB2A-4A62-99B5-098C838D8995}"/>
                </a:ext>
              </a:extLst>
            </p:cNvPr>
            <p:cNvSpPr/>
            <p:nvPr/>
          </p:nvSpPr>
          <p:spPr>
            <a:xfrm>
              <a:off x="2979922" y="4954441"/>
              <a:ext cx="2561560" cy="1259444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rgbClr val="00FF99"/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1800" b="1" dirty="0">
                <a:cs typeface="Calibri"/>
              </a:endParaRPr>
            </a:p>
            <a:p>
              <a:pPr marL="12700" algn="ctr"/>
              <a:endParaRPr lang="en-US" sz="1800" dirty="0">
                <a:cs typeface="Calibri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7275A27-3195-490F-885D-CF56DF8EF48F}"/>
                </a:ext>
              </a:extLst>
            </p:cNvPr>
            <p:cNvSpPr txBox="1"/>
            <p:nvPr/>
          </p:nvSpPr>
          <p:spPr>
            <a:xfrm>
              <a:off x="3385400" y="1838485"/>
              <a:ext cx="191790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n=</a:t>
              </a:r>
              <a:r>
                <a:rPr lang="en-US" b="1" dirty="0"/>
                <a:t>8570 </a:t>
              </a:r>
              <a:r>
                <a:rPr lang="en-US" dirty="0"/>
                <a:t>viruses with NA sequences</a:t>
              </a:r>
            </a:p>
          </p:txBody>
        </p:sp>
        <p:sp>
          <p:nvSpPr>
            <p:cNvPr id="29" name="Rectangle: Rounded Corners 28">
              <a:extLst>
                <a:ext uri="{FF2B5EF4-FFF2-40B4-BE49-F238E27FC236}">
                  <a16:creationId xmlns:a16="http://schemas.microsoft.com/office/drawing/2014/main" id="{E3A6B980-8FC4-41B0-A817-55B8283370D1}"/>
                </a:ext>
              </a:extLst>
            </p:cNvPr>
            <p:cNvSpPr/>
            <p:nvPr/>
          </p:nvSpPr>
          <p:spPr>
            <a:xfrm>
              <a:off x="3353984" y="1892124"/>
              <a:ext cx="1917903" cy="823359"/>
            </a:xfrm>
            <a:prstGeom prst="roundRect">
              <a:avLst/>
            </a:prstGeom>
            <a:noFill/>
            <a:ln w="3810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8746F0A-301F-41CA-8224-A2686B1B27A9}"/>
                </a:ext>
              </a:extLst>
            </p:cNvPr>
            <p:cNvSpPr txBox="1"/>
            <p:nvPr/>
          </p:nvSpPr>
          <p:spPr>
            <a:xfrm>
              <a:off x="1305084" y="1481003"/>
              <a:ext cx="1667444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500" b="1" dirty="0">
                  <a:solidFill>
                    <a:schemeClr val="accent2">
                      <a:lumMod val="75000"/>
                    </a:schemeClr>
                  </a:solidFill>
                </a:rPr>
                <a:t>5 WHO CCs</a:t>
              </a:r>
            </a:p>
          </p:txBody>
        </p:sp>
        <p:cxnSp>
          <p:nvCxnSpPr>
            <p:cNvPr id="36" name="Connector: Elbow 35">
              <a:extLst>
                <a:ext uri="{FF2B5EF4-FFF2-40B4-BE49-F238E27FC236}">
                  <a16:creationId xmlns:a16="http://schemas.microsoft.com/office/drawing/2014/main" id="{B2D8933A-A8C4-40E6-AA09-6AE36D26CC52}"/>
                </a:ext>
              </a:extLst>
            </p:cNvPr>
            <p:cNvCxnSpPr>
              <a:cxnSpLocks/>
              <a:stCxn id="3" idx="0"/>
              <a:endCxn id="2" idx="1"/>
            </p:cNvCxnSpPr>
            <p:nvPr/>
          </p:nvCxnSpPr>
          <p:spPr>
            <a:xfrm rot="5400000" flipH="1" flipV="1">
              <a:off x="1739219" y="1619838"/>
              <a:ext cx="959285" cy="1581307"/>
            </a:xfrm>
            <a:prstGeom prst="bentConnector2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or: Elbow 40">
              <a:extLst>
                <a:ext uri="{FF2B5EF4-FFF2-40B4-BE49-F238E27FC236}">
                  <a16:creationId xmlns:a16="http://schemas.microsoft.com/office/drawing/2014/main" id="{869AA194-4582-4F11-900C-F20AB2578A4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529173" y="4092653"/>
              <a:ext cx="1371600" cy="1554480"/>
            </a:xfrm>
            <a:prstGeom prst="bentConnector2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3447139-F77E-4694-B747-82F9AD34753F}"/>
                </a:ext>
              </a:extLst>
            </p:cNvPr>
            <p:cNvSpPr txBox="1"/>
            <p:nvPr/>
          </p:nvSpPr>
          <p:spPr>
            <a:xfrm>
              <a:off x="1618711" y="5571441"/>
              <a:ext cx="1102481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500" b="1" dirty="0">
                  <a:solidFill>
                    <a:srgbClr val="0070C0"/>
                  </a:solidFill>
                </a:rPr>
                <a:t>GISAID</a:t>
              </a:r>
            </a:p>
          </p:txBody>
        </p:sp>
        <p:sp>
          <p:nvSpPr>
            <p:cNvPr id="32" name="object 34">
              <a:extLst>
                <a:ext uri="{FF2B5EF4-FFF2-40B4-BE49-F238E27FC236}">
                  <a16:creationId xmlns:a16="http://schemas.microsoft.com/office/drawing/2014/main" id="{B7A8193E-0132-4D16-B236-A47858799327}"/>
                </a:ext>
              </a:extLst>
            </p:cNvPr>
            <p:cNvSpPr/>
            <p:nvPr/>
          </p:nvSpPr>
          <p:spPr>
            <a:xfrm>
              <a:off x="3009515" y="3267568"/>
              <a:ext cx="2529035" cy="1205432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chemeClr val="bg1"/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2000" spc="-5" dirty="0">
                <a:solidFill>
                  <a:srgbClr val="0070C0"/>
                </a:solidFill>
                <a:cs typeface="Calibri"/>
              </a:endParaRPr>
            </a:p>
          </p:txBody>
        </p:sp>
        <p:sp>
          <p:nvSpPr>
            <p:cNvPr id="50" name="object 42">
              <a:extLst>
                <a:ext uri="{FF2B5EF4-FFF2-40B4-BE49-F238E27FC236}">
                  <a16:creationId xmlns:a16="http://schemas.microsoft.com/office/drawing/2014/main" id="{F553B57A-8DD4-499A-AF4C-E7DBE44725CE}"/>
                </a:ext>
              </a:extLst>
            </p:cNvPr>
            <p:cNvSpPr txBox="1"/>
            <p:nvPr/>
          </p:nvSpPr>
          <p:spPr>
            <a:xfrm>
              <a:off x="8425008" y="2919736"/>
              <a:ext cx="2042160" cy="1311898"/>
            </a:xfrm>
            <a:prstGeom prst="rect">
              <a:avLst/>
            </a:prstGeom>
            <a:ln w="28956">
              <a:solidFill>
                <a:srgbClr val="FF0000"/>
              </a:solidFill>
            </a:ln>
          </p:spPr>
          <p:txBody>
            <a:bodyPr vert="horz" wrap="square" lIns="0" tIns="6350" rIns="0" bIns="0" rtlCol="0">
              <a:spAutoFit/>
            </a:bodyPr>
            <a:lstStyle/>
            <a:p>
              <a:pPr algn="ctr">
                <a:spcBef>
                  <a:spcPts val="50"/>
                </a:spcBef>
              </a:pPr>
              <a:r>
                <a:rPr lang="en-US" b="1" dirty="0">
                  <a:solidFill>
                    <a:srgbClr val="FF0000"/>
                  </a:solidFill>
                  <a:cs typeface="Calibri"/>
                </a:rPr>
                <a:t>0.5</a:t>
              </a:r>
              <a:r>
                <a:rPr b="1" dirty="0">
                  <a:solidFill>
                    <a:srgbClr val="FF0000"/>
                  </a:solidFill>
                  <a:cs typeface="Calibri"/>
                </a:rPr>
                <a:t>%</a:t>
              </a:r>
              <a:r>
                <a:rPr b="1" spc="-90" dirty="0">
                  <a:solidFill>
                    <a:srgbClr val="FF0000"/>
                  </a:solidFill>
                  <a:cs typeface="Calibri"/>
                </a:rPr>
                <a:t> </a:t>
              </a:r>
              <a:endParaRPr lang="en-US" b="1" spc="-90" dirty="0">
                <a:solidFill>
                  <a:srgbClr val="FF0000"/>
                </a:solidFill>
                <a:cs typeface="Calibri"/>
              </a:endParaRPr>
            </a:p>
            <a:p>
              <a:pPr algn="ctr">
                <a:spcBef>
                  <a:spcPts val="50"/>
                </a:spcBef>
              </a:pPr>
              <a:r>
                <a:rPr b="1" dirty="0">
                  <a:solidFill>
                    <a:srgbClr val="FF0000"/>
                  </a:solidFill>
                  <a:cs typeface="Calibri"/>
                </a:rPr>
                <a:t>(n=</a:t>
              </a:r>
              <a:r>
                <a:rPr lang="en-US" b="1" dirty="0">
                  <a:solidFill>
                    <a:srgbClr val="FF0000"/>
                  </a:solidFill>
                  <a:cs typeface="Calibri"/>
                </a:rPr>
                <a:t>165/35045</a:t>
              </a:r>
              <a:r>
                <a:rPr b="1" dirty="0">
                  <a:solidFill>
                    <a:srgbClr val="FF0000"/>
                  </a:solidFill>
                  <a:cs typeface="Calibri"/>
                </a:rPr>
                <a:t>)</a:t>
              </a:r>
              <a:endParaRPr dirty="0">
                <a:cs typeface="Calibri"/>
              </a:endParaRPr>
            </a:p>
            <a:p>
              <a:pPr marL="185420" marR="177165" algn="ctr">
                <a:spcBef>
                  <a:spcPts val="5"/>
                </a:spcBef>
              </a:pPr>
              <a:r>
                <a:rPr lang="en-US" sz="1600" spc="-10" dirty="0">
                  <a:solidFill>
                    <a:srgbClr val="FF0000"/>
                  </a:solidFill>
                  <a:cs typeface="Calibri"/>
                </a:rPr>
                <a:t>global</a:t>
              </a:r>
              <a:r>
                <a:rPr sz="1600" spc="-10" dirty="0">
                  <a:solidFill>
                    <a:srgbClr val="FF0000"/>
                  </a:solidFill>
                  <a:cs typeface="Calibri"/>
                </a:rPr>
                <a:t> </a:t>
              </a:r>
              <a:r>
                <a:rPr sz="1600" spc="-5" dirty="0">
                  <a:solidFill>
                    <a:srgbClr val="FF0000"/>
                  </a:solidFill>
                  <a:cs typeface="Calibri"/>
                </a:rPr>
                <a:t>frequency  of</a:t>
              </a:r>
              <a:r>
                <a:rPr sz="1600" spc="-75" dirty="0">
                  <a:solidFill>
                    <a:srgbClr val="FF0000"/>
                  </a:solidFill>
                  <a:cs typeface="Calibri"/>
                </a:rPr>
                <a:t> </a:t>
              </a:r>
              <a:r>
                <a:rPr lang="en-US" sz="1600" spc="-5" dirty="0">
                  <a:solidFill>
                    <a:srgbClr val="FF0000"/>
                  </a:solidFill>
                  <a:cs typeface="Calibri"/>
                </a:rPr>
                <a:t>RI/HRI based on markers</a:t>
              </a:r>
              <a:endParaRPr sz="1600" dirty="0">
                <a:cs typeface="Calibri"/>
              </a:endParaRPr>
            </a:p>
          </p:txBody>
        </p:sp>
        <p:sp>
          <p:nvSpPr>
            <p:cNvPr id="59" name="object 6">
              <a:extLst>
                <a:ext uri="{FF2B5EF4-FFF2-40B4-BE49-F238E27FC236}">
                  <a16:creationId xmlns:a16="http://schemas.microsoft.com/office/drawing/2014/main" id="{0839B475-5CA0-4395-9588-2EAA554777F0}"/>
                </a:ext>
              </a:extLst>
            </p:cNvPr>
            <p:cNvSpPr txBox="1"/>
            <p:nvPr/>
          </p:nvSpPr>
          <p:spPr>
            <a:xfrm>
              <a:off x="5995385" y="1043109"/>
              <a:ext cx="1186919" cy="70788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9685" algn="ctr"/>
              <a:r>
                <a:rPr spc="-5" dirty="0">
                  <a:cs typeface="Calibri"/>
                </a:rPr>
                <a:t>n=</a:t>
              </a:r>
              <a:r>
                <a:rPr lang="en-US" b="1" spc="-5" dirty="0">
                  <a:cs typeface="Calibri"/>
                </a:rPr>
                <a:t>13536</a:t>
              </a:r>
              <a:endParaRPr lang="en-US" b="1" dirty="0">
                <a:cs typeface="Calibri"/>
              </a:endParaRPr>
            </a:p>
            <a:p>
              <a:pPr marL="12700" marR="5080" indent="30480" algn="ctr"/>
              <a:r>
                <a:rPr lang="en-US" sz="1400" spc="-35" dirty="0">
                  <a:cs typeface="Calibri"/>
                </a:rPr>
                <a:t>t</a:t>
              </a:r>
              <a:r>
                <a:rPr sz="1400" spc="-35" dirty="0">
                  <a:cs typeface="Calibri"/>
                </a:rPr>
                <a:t>ested </a:t>
              </a:r>
              <a:r>
                <a:rPr sz="1400" dirty="0">
                  <a:cs typeface="Calibri"/>
                </a:rPr>
                <a:t>in</a:t>
              </a:r>
              <a:r>
                <a:rPr lang="en-US" sz="1400" dirty="0">
                  <a:cs typeface="Calibri"/>
                </a:rPr>
                <a:t> NA inhibition  assay</a:t>
              </a:r>
              <a:endParaRPr sz="1400" dirty="0">
                <a:cs typeface="Calibri"/>
              </a:endParaRPr>
            </a:p>
          </p:txBody>
        </p:sp>
        <p:sp>
          <p:nvSpPr>
            <p:cNvPr id="69" name="object 29">
              <a:extLst>
                <a:ext uri="{FF2B5EF4-FFF2-40B4-BE49-F238E27FC236}">
                  <a16:creationId xmlns:a16="http://schemas.microsoft.com/office/drawing/2014/main" id="{14F28E5E-8624-4210-8BAD-D6E7A77ABFE7}"/>
                </a:ext>
              </a:extLst>
            </p:cNvPr>
            <p:cNvSpPr/>
            <p:nvPr/>
          </p:nvSpPr>
          <p:spPr>
            <a:xfrm>
              <a:off x="5891681" y="1735646"/>
              <a:ext cx="1318892" cy="457201"/>
            </a:xfrm>
            <a:custGeom>
              <a:avLst/>
              <a:gdLst/>
              <a:ahLst/>
              <a:cxnLst/>
              <a:rect l="l" t="t" r="r" b="b"/>
              <a:pathLst>
                <a:path w="1303020" h="562610">
                  <a:moveTo>
                    <a:pt x="0" y="93726"/>
                  </a:moveTo>
                  <a:lnTo>
                    <a:pt x="7358" y="57221"/>
                  </a:lnTo>
                  <a:lnTo>
                    <a:pt x="27431" y="27431"/>
                  </a:lnTo>
                  <a:lnTo>
                    <a:pt x="57221" y="7358"/>
                  </a:lnTo>
                  <a:lnTo>
                    <a:pt x="93725" y="0"/>
                  </a:lnTo>
                  <a:lnTo>
                    <a:pt x="1209294" y="0"/>
                  </a:lnTo>
                  <a:lnTo>
                    <a:pt x="1245798" y="7358"/>
                  </a:lnTo>
                  <a:lnTo>
                    <a:pt x="1275587" y="27432"/>
                  </a:lnTo>
                  <a:lnTo>
                    <a:pt x="1295661" y="57221"/>
                  </a:lnTo>
                  <a:lnTo>
                    <a:pt x="1303020" y="93726"/>
                  </a:lnTo>
                  <a:lnTo>
                    <a:pt x="1303020" y="468630"/>
                  </a:lnTo>
                  <a:lnTo>
                    <a:pt x="1295661" y="505134"/>
                  </a:lnTo>
                  <a:lnTo>
                    <a:pt x="1275587" y="534924"/>
                  </a:lnTo>
                  <a:lnTo>
                    <a:pt x="1245798" y="554997"/>
                  </a:lnTo>
                  <a:lnTo>
                    <a:pt x="1209294" y="562356"/>
                  </a:lnTo>
                  <a:lnTo>
                    <a:pt x="93725" y="562356"/>
                  </a:lnTo>
                  <a:lnTo>
                    <a:pt x="57221" y="554997"/>
                  </a:lnTo>
                  <a:lnTo>
                    <a:pt x="27431" y="534924"/>
                  </a:lnTo>
                  <a:lnTo>
                    <a:pt x="7358" y="505134"/>
                  </a:lnTo>
                  <a:lnTo>
                    <a:pt x="0" y="468630"/>
                  </a:lnTo>
                  <a:lnTo>
                    <a:pt x="0" y="93726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8956">
              <a:solidFill>
                <a:srgbClr val="006FC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30">
              <a:extLst>
                <a:ext uri="{FF2B5EF4-FFF2-40B4-BE49-F238E27FC236}">
                  <a16:creationId xmlns:a16="http://schemas.microsoft.com/office/drawing/2014/main" id="{152F0C61-C777-478F-96B0-5F6926D6D37E}"/>
                </a:ext>
              </a:extLst>
            </p:cNvPr>
            <p:cNvSpPr txBox="1"/>
            <p:nvPr/>
          </p:nvSpPr>
          <p:spPr>
            <a:xfrm>
              <a:off x="6167082" y="1859644"/>
              <a:ext cx="924688" cy="246221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sz="1600" b="1" dirty="0">
                  <a:cs typeface="Calibri"/>
                </a:rPr>
                <a:t>n=</a:t>
              </a:r>
              <a:r>
                <a:rPr lang="en-US" sz="1600" b="1" dirty="0">
                  <a:cs typeface="Calibri"/>
                </a:rPr>
                <a:t> 2140</a:t>
              </a:r>
              <a:endParaRPr sz="1600" dirty="0">
                <a:cs typeface="Calibri"/>
              </a:endParaRPr>
            </a:p>
          </p:txBody>
        </p:sp>
        <p:sp>
          <p:nvSpPr>
            <p:cNvPr id="72" name="object 16">
              <a:extLst>
                <a:ext uri="{FF2B5EF4-FFF2-40B4-BE49-F238E27FC236}">
                  <a16:creationId xmlns:a16="http://schemas.microsoft.com/office/drawing/2014/main" id="{8523F57B-62BB-4243-9D86-9C3D69814FF5}"/>
                </a:ext>
              </a:extLst>
            </p:cNvPr>
            <p:cNvSpPr/>
            <p:nvPr/>
          </p:nvSpPr>
          <p:spPr>
            <a:xfrm>
              <a:off x="8244542" y="1262401"/>
              <a:ext cx="1600311" cy="1160632"/>
            </a:xfrm>
            <a:custGeom>
              <a:avLst/>
              <a:gdLst/>
              <a:ahLst/>
              <a:cxnLst/>
              <a:rect l="l" t="t" r="r" b="b"/>
              <a:pathLst>
                <a:path w="1551939" h="685800">
                  <a:moveTo>
                    <a:pt x="1437131" y="0"/>
                  </a:moveTo>
                  <a:lnTo>
                    <a:pt x="114300" y="0"/>
                  </a:lnTo>
                  <a:lnTo>
                    <a:pt x="69812" y="8983"/>
                  </a:lnTo>
                  <a:lnTo>
                    <a:pt x="33480" y="33480"/>
                  </a:lnTo>
                  <a:lnTo>
                    <a:pt x="8983" y="69812"/>
                  </a:lnTo>
                  <a:lnTo>
                    <a:pt x="0" y="114300"/>
                  </a:lnTo>
                  <a:lnTo>
                    <a:pt x="0" y="571500"/>
                  </a:lnTo>
                  <a:lnTo>
                    <a:pt x="8983" y="615987"/>
                  </a:lnTo>
                  <a:lnTo>
                    <a:pt x="33480" y="652319"/>
                  </a:lnTo>
                  <a:lnTo>
                    <a:pt x="69812" y="676816"/>
                  </a:lnTo>
                  <a:lnTo>
                    <a:pt x="114300" y="685800"/>
                  </a:lnTo>
                  <a:lnTo>
                    <a:pt x="1437131" y="685800"/>
                  </a:lnTo>
                  <a:lnTo>
                    <a:pt x="1481619" y="676816"/>
                  </a:lnTo>
                  <a:lnTo>
                    <a:pt x="1517951" y="652319"/>
                  </a:lnTo>
                  <a:lnTo>
                    <a:pt x="1542448" y="615987"/>
                  </a:lnTo>
                  <a:lnTo>
                    <a:pt x="1551431" y="571500"/>
                  </a:lnTo>
                  <a:lnTo>
                    <a:pt x="1551431" y="114300"/>
                  </a:lnTo>
                  <a:lnTo>
                    <a:pt x="1542448" y="69812"/>
                  </a:lnTo>
                  <a:lnTo>
                    <a:pt x="1517951" y="33480"/>
                  </a:lnTo>
                  <a:lnTo>
                    <a:pt x="1481619" y="8983"/>
                  </a:lnTo>
                  <a:lnTo>
                    <a:pt x="1437131" y="0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5400">
              <a:solidFill>
                <a:schemeClr val="accent2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18">
              <a:extLst>
                <a:ext uri="{FF2B5EF4-FFF2-40B4-BE49-F238E27FC236}">
                  <a16:creationId xmlns:a16="http://schemas.microsoft.com/office/drawing/2014/main" id="{72D68181-E5B9-4A12-88E1-CD2E553DD777}"/>
                </a:ext>
              </a:extLst>
            </p:cNvPr>
            <p:cNvSpPr txBox="1"/>
            <p:nvPr/>
          </p:nvSpPr>
          <p:spPr>
            <a:xfrm>
              <a:off x="8245120" y="1238240"/>
              <a:ext cx="1600311" cy="1107996"/>
            </a:xfrm>
            <a:prstGeom prst="rect">
              <a:avLst/>
            </a:prstGeom>
            <a:ln>
              <a:noFill/>
            </a:ln>
          </p:spPr>
          <p:txBody>
            <a:bodyPr vert="horz" wrap="square" lIns="0" tIns="0" rIns="0" bIns="0" rtlCol="0">
              <a:spAutoFit/>
            </a:bodyPr>
            <a:lstStyle/>
            <a:p>
              <a:pPr marL="1270" algn="ctr"/>
              <a:r>
                <a:rPr dirty="0">
                  <a:cs typeface="Calibri"/>
                </a:rPr>
                <a:t>n=</a:t>
              </a:r>
              <a:r>
                <a:rPr lang="en-US" dirty="0">
                  <a:cs typeface="Calibri"/>
                </a:rPr>
                <a:t> </a:t>
              </a:r>
              <a:r>
                <a:rPr lang="en-US" b="1" dirty="0">
                  <a:cs typeface="Calibri"/>
                </a:rPr>
                <a:t>97</a:t>
              </a:r>
              <a:r>
                <a:rPr spc="-95" dirty="0">
                  <a:cs typeface="Calibri"/>
                </a:rPr>
                <a:t> </a:t>
              </a:r>
              <a:r>
                <a:rPr lang="en-US" spc="-95" dirty="0">
                  <a:cs typeface="Calibri"/>
                </a:rPr>
                <a:t> </a:t>
              </a:r>
            </a:p>
            <a:p>
              <a:pPr marL="1270" algn="ctr"/>
              <a:r>
                <a:rPr lang="en-US" spc="-95" dirty="0">
                  <a:cs typeface="Calibri"/>
                </a:rPr>
                <a:t>with markers </a:t>
              </a:r>
              <a:r>
                <a:rPr dirty="0">
                  <a:cs typeface="Calibri"/>
                </a:rPr>
                <a:t>&amp;</a:t>
              </a:r>
            </a:p>
            <a:p>
              <a:pPr algn="ctr">
                <a:lnSpc>
                  <a:spcPct val="100000"/>
                </a:lnSpc>
              </a:pPr>
              <a:r>
                <a:rPr lang="en-US" b="1" dirty="0">
                  <a:cs typeface="Calibri"/>
                </a:rPr>
                <a:t>RI/HRI </a:t>
              </a:r>
              <a:r>
                <a:rPr lang="en-US" dirty="0">
                  <a:cs typeface="Calibri"/>
                </a:rPr>
                <a:t>in NA inhibition assay</a:t>
              </a:r>
              <a:endParaRPr dirty="0">
                <a:cs typeface="Calibri"/>
              </a:endParaRPr>
            </a:p>
          </p:txBody>
        </p:sp>
        <p:sp>
          <p:nvSpPr>
            <p:cNvPr id="80" name="Arrow: Right 79">
              <a:extLst>
                <a:ext uri="{FF2B5EF4-FFF2-40B4-BE49-F238E27FC236}">
                  <a16:creationId xmlns:a16="http://schemas.microsoft.com/office/drawing/2014/main" id="{EED4FEC6-3793-4465-AAE6-9B37E305F78C}"/>
                </a:ext>
              </a:extLst>
            </p:cNvPr>
            <p:cNvSpPr/>
            <p:nvPr/>
          </p:nvSpPr>
          <p:spPr>
            <a:xfrm>
              <a:off x="5549193" y="5364673"/>
              <a:ext cx="1420654" cy="301752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object 23">
              <a:extLst>
                <a:ext uri="{FF2B5EF4-FFF2-40B4-BE49-F238E27FC236}">
                  <a16:creationId xmlns:a16="http://schemas.microsoft.com/office/drawing/2014/main" id="{62322166-203F-423C-A303-6B7A22D466E1}"/>
                </a:ext>
              </a:extLst>
            </p:cNvPr>
            <p:cNvSpPr/>
            <p:nvPr/>
          </p:nvSpPr>
          <p:spPr>
            <a:xfrm>
              <a:off x="5749496" y="1930574"/>
              <a:ext cx="148455" cy="913435"/>
            </a:xfrm>
            <a:custGeom>
              <a:avLst/>
              <a:gdLst/>
              <a:ahLst/>
              <a:cxnLst/>
              <a:rect l="l" t="t" r="r" b="b"/>
              <a:pathLst>
                <a:path w="346075" h="2153920">
                  <a:moveTo>
                    <a:pt x="345947" y="2153412"/>
                  </a:moveTo>
                  <a:lnTo>
                    <a:pt x="211312" y="2153412"/>
                  </a:lnTo>
                  <a:lnTo>
                    <a:pt x="101345" y="2153412"/>
                  </a:lnTo>
                  <a:lnTo>
                    <a:pt x="27193" y="2153412"/>
                  </a:lnTo>
                  <a:lnTo>
                    <a:pt x="0" y="2153412"/>
                  </a:lnTo>
                  <a:lnTo>
                    <a:pt x="0" y="0"/>
                  </a:lnTo>
                  <a:lnTo>
                    <a:pt x="27193" y="0"/>
                  </a:lnTo>
                  <a:lnTo>
                    <a:pt x="101345" y="0"/>
                  </a:lnTo>
                  <a:lnTo>
                    <a:pt x="211312" y="0"/>
                  </a:lnTo>
                  <a:lnTo>
                    <a:pt x="345947" y="0"/>
                  </a:lnTo>
                </a:path>
              </a:pathLst>
            </a:custGeom>
            <a:ln w="28956">
              <a:solidFill>
                <a:srgbClr val="006FC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34">
              <a:extLst>
                <a:ext uri="{FF2B5EF4-FFF2-40B4-BE49-F238E27FC236}">
                  <a16:creationId xmlns:a16="http://schemas.microsoft.com/office/drawing/2014/main" id="{096298BB-21BA-421B-A0E3-C609479CB7E3}"/>
                </a:ext>
              </a:extLst>
            </p:cNvPr>
            <p:cNvSpPr/>
            <p:nvPr/>
          </p:nvSpPr>
          <p:spPr>
            <a:xfrm>
              <a:off x="5861664" y="2479169"/>
              <a:ext cx="1684148" cy="1046615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chemeClr val="accent4">
                <a:lumMod val="40000"/>
                <a:lumOff val="60000"/>
              </a:schemeClr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1400" b="1" dirty="0">
                <a:cs typeface="Calibri"/>
              </a:endParaRPr>
            </a:p>
          </p:txBody>
        </p:sp>
        <p:sp>
          <p:nvSpPr>
            <p:cNvPr id="8" name="object 13">
              <a:extLst>
                <a:ext uri="{FF2B5EF4-FFF2-40B4-BE49-F238E27FC236}">
                  <a16:creationId xmlns:a16="http://schemas.microsoft.com/office/drawing/2014/main" id="{6BA6322E-912A-4AC6-96F6-04E6478E9861}"/>
                </a:ext>
              </a:extLst>
            </p:cNvPr>
            <p:cNvSpPr/>
            <p:nvPr/>
          </p:nvSpPr>
          <p:spPr>
            <a:xfrm>
              <a:off x="7013107" y="5085076"/>
              <a:ext cx="1818356" cy="907650"/>
            </a:xfrm>
            <a:custGeom>
              <a:avLst/>
              <a:gdLst/>
              <a:ahLst/>
              <a:cxnLst/>
              <a:rect l="l" t="t" r="r" b="b"/>
              <a:pathLst>
                <a:path w="1407160" h="609600">
                  <a:moveTo>
                    <a:pt x="1305052" y="0"/>
                  </a:moveTo>
                  <a:lnTo>
                    <a:pt x="101600" y="0"/>
                  </a:lnTo>
                  <a:lnTo>
                    <a:pt x="62043" y="7981"/>
                  </a:lnTo>
                  <a:lnTo>
                    <a:pt x="29749" y="29749"/>
                  </a:lnTo>
                  <a:lnTo>
                    <a:pt x="7981" y="62043"/>
                  </a:lnTo>
                  <a:lnTo>
                    <a:pt x="0" y="101599"/>
                  </a:lnTo>
                  <a:lnTo>
                    <a:pt x="0" y="507999"/>
                  </a:lnTo>
                  <a:lnTo>
                    <a:pt x="7981" y="547556"/>
                  </a:lnTo>
                  <a:lnTo>
                    <a:pt x="29749" y="579850"/>
                  </a:lnTo>
                  <a:lnTo>
                    <a:pt x="62043" y="601618"/>
                  </a:lnTo>
                  <a:lnTo>
                    <a:pt x="101600" y="609599"/>
                  </a:lnTo>
                  <a:lnTo>
                    <a:pt x="1305052" y="609599"/>
                  </a:lnTo>
                  <a:lnTo>
                    <a:pt x="1344608" y="601618"/>
                  </a:lnTo>
                  <a:lnTo>
                    <a:pt x="1376902" y="579850"/>
                  </a:lnTo>
                  <a:lnTo>
                    <a:pt x="1398670" y="547556"/>
                  </a:lnTo>
                  <a:lnTo>
                    <a:pt x="1406652" y="507999"/>
                  </a:lnTo>
                  <a:lnTo>
                    <a:pt x="1406652" y="101599"/>
                  </a:lnTo>
                  <a:lnTo>
                    <a:pt x="1398670" y="62043"/>
                  </a:lnTo>
                  <a:lnTo>
                    <a:pt x="1376902" y="29749"/>
                  </a:lnTo>
                  <a:lnTo>
                    <a:pt x="1344608" y="7981"/>
                  </a:lnTo>
                  <a:lnTo>
                    <a:pt x="1305052" y="0"/>
                  </a:lnTo>
                  <a:close/>
                </a:path>
              </a:pathLst>
            </a:custGeom>
            <a:solidFill>
              <a:srgbClr val="00FF99"/>
            </a:solidFill>
            <a:ln>
              <a:solidFill>
                <a:schemeClr val="accent1"/>
              </a:solidFill>
            </a:ln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9" name="object 14">
              <a:extLst>
                <a:ext uri="{FF2B5EF4-FFF2-40B4-BE49-F238E27FC236}">
                  <a16:creationId xmlns:a16="http://schemas.microsoft.com/office/drawing/2014/main" id="{D9BEC6EB-DB02-43A4-8EB3-260DC4A34733}"/>
                </a:ext>
              </a:extLst>
            </p:cNvPr>
            <p:cNvSpPr/>
            <p:nvPr/>
          </p:nvSpPr>
          <p:spPr>
            <a:xfrm>
              <a:off x="7013107" y="5085665"/>
              <a:ext cx="1818356" cy="907650"/>
            </a:xfrm>
            <a:custGeom>
              <a:avLst/>
              <a:gdLst/>
              <a:ahLst/>
              <a:cxnLst/>
              <a:rect l="l" t="t" r="r" b="b"/>
              <a:pathLst>
                <a:path w="1407160" h="609600">
                  <a:moveTo>
                    <a:pt x="0" y="101599"/>
                  </a:moveTo>
                  <a:lnTo>
                    <a:pt x="7981" y="62043"/>
                  </a:lnTo>
                  <a:lnTo>
                    <a:pt x="29749" y="29749"/>
                  </a:lnTo>
                  <a:lnTo>
                    <a:pt x="62043" y="7981"/>
                  </a:lnTo>
                  <a:lnTo>
                    <a:pt x="101600" y="0"/>
                  </a:lnTo>
                  <a:lnTo>
                    <a:pt x="1305052" y="0"/>
                  </a:lnTo>
                  <a:lnTo>
                    <a:pt x="1344608" y="7981"/>
                  </a:lnTo>
                  <a:lnTo>
                    <a:pt x="1376902" y="29749"/>
                  </a:lnTo>
                  <a:lnTo>
                    <a:pt x="1398670" y="62043"/>
                  </a:lnTo>
                  <a:lnTo>
                    <a:pt x="1406652" y="101599"/>
                  </a:lnTo>
                  <a:lnTo>
                    <a:pt x="1406652" y="507999"/>
                  </a:lnTo>
                  <a:lnTo>
                    <a:pt x="1398670" y="547556"/>
                  </a:lnTo>
                  <a:lnTo>
                    <a:pt x="1376902" y="579850"/>
                  </a:lnTo>
                  <a:lnTo>
                    <a:pt x="1344608" y="601618"/>
                  </a:lnTo>
                  <a:lnTo>
                    <a:pt x="1305052" y="609599"/>
                  </a:lnTo>
                  <a:lnTo>
                    <a:pt x="101600" y="609599"/>
                  </a:lnTo>
                  <a:lnTo>
                    <a:pt x="62043" y="601618"/>
                  </a:lnTo>
                  <a:lnTo>
                    <a:pt x="29749" y="579850"/>
                  </a:lnTo>
                  <a:lnTo>
                    <a:pt x="7981" y="547556"/>
                  </a:lnTo>
                  <a:lnTo>
                    <a:pt x="0" y="507999"/>
                  </a:lnTo>
                  <a:lnTo>
                    <a:pt x="0" y="101599"/>
                  </a:lnTo>
                  <a:close/>
                </a:path>
              </a:pathLst>
            </a:custGeom>
            <a:solidFill>
              <a:srgbClr val="00FF99"/>
            </a:solidFill>
            <a:ln w="28575">
              <a:solidFill>
                <a:schemeClr val="accent1"/>
              </a:solidFill>
            </a:ln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0" name="object 15">
              <a:extLst>
                <a:ext uri="{FF2B5EF4-FFF2-40B4-BE49-F238E27FC236}">
                  <a16:creationId xmlns:a16="http://schemas.microsoft.com/office/drawing/2014/main" id="{B1C92DF9-0F49-4861-99C4-A9453B3E3C12}"/>
                </a:ext>
              </a:extLst>
            </p:cNvPr>
            <p:cNvSpPr txBox="1"/>
            <p:nvPr/>
          </p:nvSpPr>
          <p:spPr>
            <a:xfrm>
              <a:off x="7272124" y="5123402"/>
              <a:ext cx="1152884" cy="830997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0" tIns="0" rIns="0" bIns="0" rtlCol="0">
              <a:spAutoFit/>
            </a:bodyPr>
            <a:lstStyle/>
            <a:p>
              <a:pPr marL="1270" algn="ctr"/>
              <a:r>
                <a:rPr spc="-5" dirty="0">
                  <a:cs typeface="Calibri"/>
                </a:rPr>
                <a:t>n=</a:t>
              </a:r>
              <a:r>
                <a:rPr lang="en-US" b="1" spc="-5" dirty="0">
                  <a:cs typeface="Calibri"/>
                </a:rPr>
                <a:t>68</a:t>
              </a:r>
              <a:endParaRPr dirty="0">
                <a:cs typeface="Calibri"/>
              </a:endParaRPr>
            </a:p>
            <a:p>
              <a:pPr algn="ctr">
                <a:lnSpc>
                  <a:spcPct val="100000"/>
                </a:lnSpc>
              </a:pPr>
              <a:r>
                <a:rPr lang="en-US" dirty="0">
                  <a:cs typeface="Calibri"/>
                </a:rPr>
                <a:t>with </a:t>
              </a:r>
              <a:r>
                <a:rPr lang="en-US" b="1" dirty="0">
                  <a:cs typeface="Calibri"/>
                </a:rPr>
                <a:t>RI/HRI </a:t>
              </a:r>
              <a:r>
                <a:rPr lang="en-US" dirty="0">
                  <a:cs typeface="Calibri"/>
                </a:rPr>
                <a:t>marker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A80227E-B68A-4743-AAF4-0DB26BBDE58C}"/>
                </a:ext>
              </a:extLst>
            </p:cNvPr>
            <p:cNvSpPr txBox="1"/>
            <p:nvPr/>
          </p:nvSpPr>
          <p:spPr>
            <a:xfrm>
              <a:off x="3221727" y="3414711"/>
              <a:ext cx="2147580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sz="1800" dirty="0">
                  <a:cs typeface="Calibri"/>
                </a:rPr>
                <a:t>n</a:t>
              </a:r>
              <a:r>
                <a:rPr lang="en-US" sz="1800" spc="-5" dirty="0">
                  <a:cs typeface="Calibri"/>
                </a:rPr>
                <a:t>=</a:t>
              </a:r>
              <a:r>
                <a:rPr lang="en-US" sz="1800" b="1" spc="-5" dirty="0">
                  <a:cs typeface="Calibri"/>
                </a:rPr>
                <a:t>23649 </a:t>
              </a:r>
              <a:r>
                <a:rPr lang="en-US" sz="1800" spc="-5" dirty="0">
                  <a:cs typeface="Calibri"/>
                </a:rPr>
                <a:t>viruses</a:t>
              </a:r>
            </a:p>
            <a:p>
              <a:pPr marL="12700" algn="ctr"/>
              <a:r>
                <a:rPr lang="en-US" sz="1800" dirty="0">
                  <a:cs typeface="Calibri"/>
                </a:rPr>
                <a:t>with NA </a:t>
              </a:r>
              <a:r>
                <a:rPr lang="en-US" sz="1800" spc="-5" dirty="0">
                  <a:cs typeface="Calibri"/>
                </a:rPr>
                <a:t>sequences</a:t>
              </a:r>
              <a:r>
                <a:rPr lang="en-US" sz="1800" spc="-60" dirty="0">
                  <a:cs typeface="Calibri"/>
                </a:rPr>
                <a:t> </a:t>
              </a:r>
              <a:r>
                <a:rPr lang="en-US" sz="1800" b="1" dirty="0">
                  <a:cs typeface="Calibri"/>
                </a:rPr>
                <a:t>in  </a:t>
              </a:r>
              <a:r>
                <a:rPr lang="en-US" sz="1800" b="1" spc="-5" dirty="0">
                  <a:cs typeface="Calibri"/>
                </a:rPr>
                <a:t>GISAID</a:t>
              </a:r>
            </a:p>
          </p:txBody>
        </p:sp>
        <p:sp>
          <p:nvSpPr>
            <p:cNvPr id="12" name="Arrow: Right 11">
              <a:extLst>
                <a:ext uri="{FF2B5EF4-FFF2-40B4-BE49-F238E27FC236}">
                  <a16:creationId xmlns:a16="http://schemas.microsoft.com/office/drawing/2014/main" id="{9C422631-B367-46F2-99A5-E31BF2F320BC}"/>
                </a:ext>
              </a:extLst>
            </p:cNvPr>
            <p:cNvSpPr/>
            <p:nvPr/>
          </p:nvSpPr>
          <p:spPr>
            <a:xfrm rot="16200000">
              <a:off x="4092073" y="2884749"/>
              <a:ext cx="424014" cy="341624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row: Right 42">
              <a:extLst>
                <a:ext uri="{FF2B5EF4-FFF2-40B4-BE49-F238E27FC236}">
                  <a16:creationId xmlns:a16="http://schemas.microsoft.com/office/drawing/2014/main" id="{E32B6613-6CF0-4F99-8D53-E28A246292D5}"/>
                </a:ext>
              </a:extLst>
            </p:cNvPr>
            <p:cNvSpPr/>
            <p:nvPr/>
          </p:nvSpPr>
          <p:spPr>
            <a:xfrm rot="5400000" flipV="1">
              <a:off x="4054840" y="4514195"/>
              <a:ext cx="424014" cy="341624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0BA1FA0-A1BA-4575-8D9C-681845EF6E81}"/>
                </a:ext>
              </a:extLst>
            </p:cNvPr>
            <p:cNvSpPr txBox="1"/>
            <p:nvPr/>
          </p:nvSpPr>
          <p:spPr>
            <a:xfrm>
              <a:off x="2902171" y="4939326"/>
              <a:ext cx="2688738" cy="110799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dirty="0">
                  <a:cs typeface="Calibri"/>
                </a:rPr>
                <a:t>n</a:t>
              </a:r>
              <a:r>
                <a:rPr lang="en-US" spc="-5" dirty="0">
                  <a:cs typeface="Calibri"/>
                </a:rPr>
                <a:t>=</a:t>
              </a:r>
              <a:r>
                <a:rPr lang="en-US" b="1" spc="-5" dirty="0">
                  <a:cs typeface="Calibri"/>
                </a:rPr>
                <a:t>15079</a:t>
              </a:r>
            </a:p>
            <a:p>
              <a:pPr marL="12700" algn="ctr"/>
              <a:r>
                <a:rPr lang="en-US" sz="1600" dirty="0">
                  <a:cs typeface="Calibri"/>
                </a:rPr>
                <a:t>viruses with </a:t>
              </a:r>
            </a:p>
            <a:p>
              <a:pPr marL="12700" algn="ctr"/>
              <a:r>
                <a:rPr lang="en-US" sz="1600" dirty="0">
                  <a:cs typeface="Calibri"/>
                </a:rPr>
                <a:t>NA sequences </a:t>
              </a:r>
            </a:p>
            <a:p>
              <a:pPr marL="12700" algn="ctr"/>
              <a:r>
                <a:rPr lang="en-US" sz="1600" b="1" dirty="0">
                  <a:cs typeface="Calibri"/>
                </a:rPr>
                <a:t>NOT analyzed by WHO CC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36D7A9B-D9D5-40B9-B149-812450694935}"/>
                </a:ext>
              </a:extLst>
            </p:cNvPr>
            <p:cNvSpPr txBox="1"/>
            <p:nvPr/>
          </p:nvSpPr>
          <p:spPr>
            <a:xfrm>
              <a:off x="5744142" y="2498996"/>
              <a:ext cx="1818356" cy="116955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sz="1400" dirty="0">
                  <a:latin typeface="Calibri" panose="020F0502020204030204" pitchFamily="34" charset="0"/>
                </a:rPr>
                <a:t>n</a:t>
              </a:r>
              <a:r>
                <a:rPr lang="en-US" sz="1400" i="0" u="none" strike="noStrike" dirty="0">
                  <a:effectLst/>
                  <a:latin typeface="Calibri" panose="020F0502020204030204" pitchFamily="34" charset="0"/>
                </a:rPr>
                <a:t>=</a:t>
              </a:r>
              <a:r>
                <a:rPr lang="en-US" sz="1400" b="1" i="0" u="none" strike="noStrike" dirty="0">
                  <a:effectLst/>
                  <a:latin typeface="Calibri" panose="020F0502020204030204" pitchFamily="34" charset="0"/>
                </a:rPr>
                <a:t>6430</a:t>
              </a:r>
            </a:p>
            <a:p>
              <a:pPr marL="12700" algn="ctr"/>
              <a:r>
                <a:rPr lang="en-US" sz="1400" dirty="0">
                  <a:cs typeface="Calibri"/>
                </a:rPr>
                <a:t>viruses pre-screened by Atlanta CC</a:t>
              </a:r>
            </a:p>
            <a:p>
              <a:pPr marL="12700" algn="ctr"/>
              <a:r>
                <a:rPr lang="en-US" sz="1400" b="1" dirty="0">
                  <a:cs typeface="Calibri"/>
                </a:rPr>
                <a:t>NO RI/HRI</a:t>
              </a:r>
              <a:r>
                <a:rPr lang="en-US" sz="1400" dirty="0">
                  <a:cs typeface="Calibri"/>
                </a:rPr>
                <a:t> markers</a:t>
              </a:r>
            </a:p>
            <a:p>
              <a:pPr marL="12700" algn="ctr"/>
              <a:endParaRPr lang="en-US" sz="1400" b="1" dirty="0">
                <a:cs typeface="Calibri"/>
              </a:endParaRP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3CCDDFF-C1E5-41CC-AD47-C010AECEE0B3}"/>
                </a:ext>
              </a:extLst>
            </p:cNvPr>
            <p:cNvCxnSpPr>
              <a:cxnSpLocks/>
              <a:stCxn id="29" idx="3"/>
            </p:cNvCxnSpPr>
            <p:nvPr/>
          </p:nvCxnSpPr>
          <p:spPr>
            <a:xfrm flipV="1">
              <a:off x="5271887" y="2290354"/>
              <a:ext cx="472254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11727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itle 1">
            <a:extLst>
              <a:ext uri="{FF2B5EF4-FFF2-40B4-BE49-F238E27FC236}">
                <a16:creationId xmlns:a16="http://schemas.microsoft.com/office/drawing/2014/main" id="{EDBDA644-D249-4D91-B497-070836DE1590}"/>
              </a:ext>
            </a:extLst>
          </p:cNvPr>
          <p:cNvSpPr txBox="1">
            <a:spLocks/>
          </p:cNvSpPr>
          <p:nvPr/>
        </p:nvSpPr>
        <p:spPr>
          <a:xfrm>
            <a:off x="394419" y="197631"/>
            <a:ext cx="11464603" cy="46779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b="1" dirty="0">
                <a:solidFill>
                  <a:schemeClr val="accent1">
                    <a:lumMod val="75000"/>
                  </a:schemeClr>
                </a:solidFill>
              </a:rPr>
              <a:t>Fig. S2. NAI susceptibility data analysis flowchart: 2019-2020 period</a:t>
            </a:r>
          </a:p>
        </p:txBody>
      </p:sp>
      <p:sp>
        <p:nvSpPr>
          <p:cNvPr id="61" name="Slide Number Placeholder 7">
            <a:extLst>
              <a:ext uri="{FF2B5EF4-FFF2-40B4-BE49-F238E27FC236}">
                <a16:creationId xmlns:a16="http://schemas.microsoft.com/office/drawing/2014/main" id="{75A99F03-5D0D-4BA1-BF09-EA5B661E35DA}"/>
              </a:ext>
            </a:extLst>
          </p:cNvPr>
          <p:cNvSpPr txBox="1">
            <a:spLocks/>
          </p:cNvSpPr>
          <p:nvPr/>
        </p:nvSpPr>
        <p:spPr>
          <a:xfrm>
            <a:off x="9045276" y="257231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32F5A1F4-4370-4CBB-A432-5A4DC939E9C2}" type="slidenum">
              <a:rPr lang="en-US" smtClean="0"/>
              <a:pPr/>
              <a:t>2</a:t>
            </a:fld>
            <a:endParaRPr lang="en-US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C0B7C72-4C20-4BB9-9368-7FF9DE6E3940}"/>
              </a:ext>
            </a:extLst>
          </p:cNvPr>
          <p:cNvGrpSpPr/>
          <p:nvPr/>
        </p:nvGrpSpPr>
        <p:grpSpPr>
          <a:xfrm>
            <a:off x="1243318" y="1091814"/>
            <a:ext cx="9754102" cy="5294078"/>
            <a:chOff x="582434" y="919807"/>
            <a:chExt cx="9754102" cy="5294078"/>
          </a:xfrm>
        </p:grpSpPr>
        <p:cxnSp>
          <p:nvCxnSpPr>
            <p:cNvPr id="20" name="Connector: Curved 19">
              <a:extLst>
                <a:ext uri="{FF2B5EF4-FFF2-40B4-BE49-F238E27FC236}">
                  <a16:creationId xmlns:a16="http://schemas.microsoft.com/office/drawing/2014/main" id="{90398FD7-A0ED-40A1-8E44-29FF2539F59F}"/>
                </a:ext>
              </a:extLst>
            </p:cNvPr>
            <p:cNvCxnSpPr>
              <a:cxnSpLocks/>
              <a:stCxn id="74" idx="3"/>
            </p:cNvCxnSpPr>
            <p:nvPr/>
          </p:nvCxnSpPr>
          <p:spPr>
            <a:xfrm flipH="1">
              <a:off x="9515845" y="1696929"/>
              <a:ext cx="347074" cy="1106258"/>
            </a:xfrm>
            <a:prstGeom prst="curvedConnector4">
              <a:avLst>
                <a:gd name="adj1" fmla="val -65865"/>
                <a:gd name="adj2" fmla="val 75735"/>
              </a:avLst>
            </a:prstGeom>
            <a:ln w="38100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or: Curved 55">
              <a:extLst>
                <a:ext uri="{FF2B5EF4-FFF2-40B4-BE49-F238E27FC236}">
                  <a16:creationId xmlns:a16="http://schemas.microsoft.com/office/drawing/2014/main" id="{AB7DE794-B312-4B93-99DF-87AFB901812C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8062221" y="4244714"/>
              <a:ext cx="1218901" cy="829069"/>
            </a:xfrm>
            <a:prstGeom prst="curvedConnector3">
              <a:avLst>
                <a:gd name="adj1" fmla="val 503"/>
              </a:avLst>
            </a:prstGeom>
            <a:ln w="38100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Arrow: Right 66">
              <a:extLst>
                <a:ext uri="{FF2B5EF4-FFF2-40B4-BE49-F238E27FC236}">
                  <a16:creationId xmlns:a16="http://schemas.microsoft.com/office/drawing/2014/main" id="{CAA1ECF0-170F-455E-A667-52D9ABF59F13}"/>
                </a:ext>
              </a:extLst>
            </p:cNvPr>
            <p:cNvSpPr/>
            <p:nvPr/>
          </p:nvSpPr>
          <p:spPr>
            <a:xfrm>
              <a:off x="7331872" y="1455460"/>
              <a:ext cx="869692" cy="299567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object 5">
              <a:extLst>
                <a:ext uri="{FF2B5EF4-FFF2-40B4-BE49-F238E27FC236}">
                  <a16:creationId xmlns:a16="http://schemas.microsoft.com/office/drawing/2014/main" id="{337DE74F-00E4-4414-AF95-A3BE1C67F343}"/>
                </a:ext>
              </a:extLst>
            </p:cNvPr>
            <p:cNvSpPr/>
            <p:nvPr/>
          </p:nvSpPr>
          <p:spPr>
            <a:xfrm>
              <a:off x="5856462" y="936985"/>
              <a:ext cx="1516886" cy="1398958"/>
            </a:xfrm>
            <a:custGeom>
              <a:avLst/>
              <a:gdLst/>
              <a:ahLst/>
              <a:cxnLst/>
              <a:rect l="l" t="t" r="r" b="b"/>
              <a:pathLst>
                <a:path w="1582420" h="1769745">
                  <a:moveTo>
                    <a:pt x="1318260" y="0"/>
                  </a:moveTo>
                  <a:lnTo>
                    <a:pt x="263652" y="0"/>
                  </a:lnTo>
                  <a:lnTo>
                    <a:pt x="216244" y="4245"/>
                  </a:lnTo>
                  <a:lnTo>
                    <a:pt x="171631" y="16488"/>
                  </a:lnTo>
                  <a:lnTo>
                    <a:pt x="130556" y="35983"/>
                  </a:lnTo>
                  <a:lnTo>
                    <a:pt x="93760" y="61988"/>
                  </a:lnTo>
                  <a:lnTo>
                    <a:pt x="61988" y="93760"/>
                  </a:lnTo>
                  <a:lnTo>
                    <a:pt x="35983" y="130556"/>
                  </a:lnTo>
                  <a:lnTo>
                    <a:pt x="16488" y="171631"/>
                  </a:lnTo>
                  <a:lnTo>
                    <a:pt x="4245" y="216244"/>
                  </a:lnTo>
                  <a:lnTo>
                    <a:pt x="0" y="263651"/>
                  </a:lnTo>
                  <a:lnTo>
                    <a:pt x="0" y="1505712"/>
                  </a:lnTo>
                  <a:lnTo>
                    <a:pt x="4245" y="1553119"/>
                  </a:lnTo>
                  <a:lnTo>
                    <a:pt x="16488" y="1597732"/>
                  </a:lnTo>
                  <a:lnTo>
                    <a:pt x="35983" y="1638807"/>
                  </a:lnTo>
                  <a:lnTo>
                    <a:pt x="61988" y="1675603"/>
                  </a:lnTo>
                  <a:lnTo>
                    <a:pt x="93760" y="1707375"/>
                  </a:lnTo>
                  <a:lnTo>
                    <a:pt x="130556" y="1733380"/>
                  </a:lnTo>
                  <a:lnTo>
                    <a:pt x="171631" y="1752875"/>
                  </a:lnTo>
                  <a:lnTo>
                    <a:pt x="216244" y="1765118"/>
                  </a:lnTo>
                  <a:lnTo>
                    <a:pt x="263652" y="1769364"/>
                  </a:lnTo>
                  <a:lnTo>
                    <a:pt x="1318260" y="1769364"/>
                  </a:lnTo>
                  <a:lnTo>
                    <a:pt x="1365667" y="1765118"/>
                  </a:lnTo>
                  <a:lnTo>
                    <a:pt x="1410280" y="1752875"/>
                  </a:lnTo>
                  <a:lnTo>
                    <a:pt x="1451355" y="1733380"/>
                  </a:lnTo>
                  <a:lnTo>
                    <a:pt x="1488151" y="1707375"/>
                  </a:lnTo>
                  <a:lnTo>
                    <a:pt x="1519923" y="1675603"/>
                  </a:lnTo>
                  <a:lnTo>
                    <a:pt x="1545928" y="1638807"/>
                  </a:lnTo>
                  <a:lnTo>
                    <a:pt x="1565423" y="1597732"/>
                  </a:lnTo>
                  <a:lnTo>
                    <a:pt x="1577666" y="1553119"/>
                  </a:lnTo>
                  <a:lnTo>
                    <a:pt x="1581912" y="1505712"/>
                  </a:lnTo>
                  <a:lnTo>
                    <a:pt x="1581912" y="263651"/>
                  </a:lnTo>
                  <a:lnTo>
                    <a:pt x="1577666" y="216244"/>
                  </a:lnTo>
                  <a:lnTo>
                    <a:pt x="1565423" y="171631"/>
                  </a:lnTo>
                  <a:lnTo>
                    <a:pt x="1545928" y="130556"/>
                  </a:lnTo>
                  <a:lnTo>
                    <a:pt x="1519923" y="93760"/>
                  </a:lnTo>
                  <a:lnTo>
                    <a:pt x="1488151" y="61988"/>
                  </a:lnTo>
                  <a:lnTo>
                    <a:pt x="1451356" y="35983"/>
                  </a:lnTo>
                  <a:lnTo>
                    <a:pt x="1410280" y="16488"/>
                  </a:lnTo>
                  <a:lnTo>
                    <a:pt x="1365667" y="4245"/>
                  </a:lnTo>
                  <a:lnTo>
                    <a:pt x="1318260" y="0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5400">
              <a:solidFill>
                <a:schemeClr val="accent2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" name="object 41">
              <a:extLst>
                <a:ext uri="{FF2B5EF4-FFF2-40B4-BE49-F238E27FC236}">
                  <a16:creationId xmlns:a16="http://schemas.microsoft.com/office/drawing/2014/main" id="{E0553CCF-6BC2-4EFF-AF18-69CD9EB7608C}"/>
                </a:ext>
              </a:extLst>
            </p:cNvPr>
            <p:cNvSpPr txBox="1"/>
            <p:nvPr/>
          </p:nvSpPr>
          <p:spPr>
            <a:xfrm>
              <a:off x="3009515" y="1060097"/>
              <a:ext cx="2529035" cy="1741502"/>
            </a:xfrm>
            <a:prstGeom prst="rect">
              <a:avLst/>
            </a:prstGeom>
            <a:ln w="28956">
              <a:solidFill>
                <a:srgbClr val="000000"/>
              </a:solidFill>
            </a:ln>
          </p:spPr>
          <p:txBody>
            <a:bodyPr vert="horz" wrap="square" lIns="0" tIns="147320" rIns="0" bIns="0" rtlCol="0">
              <a:spAutoFit/>
            </a:bodyPr>
            <a:lstStyle/>
            <a:p>
              <a:pPr algn="ctr"/>
              <a:r>
                <a:rPr sz="2000" dirty="0">
                  <a:cs typeface="Calibri"/>
                </a:rPr>
                <a:t>n=</a:t>
              </a:r>
              <a:r>
                <a:rPr lang="en-US" b="1" dirty="0">
                  <a:solidFill>
                    <a:srgbClr val="000000"/>
                  </a:solidFill>
                </a:rPr>
                <a:t>15582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 </a:t>
              </a:r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viruses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 </a:t>
              </a:r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analyzed </a:t>
              </a:r>
            </a:p>
            <a:p>
              <a:pPr algn="ctr"/>
              <a:r>
                <a:rPr lang="en-US" sz="1800" i="0" u="none" strike="noStrike" dirty="0">
                  <a:solidFill>
                    <a:srgbClr val="000000"/>
                  </a:solidFill>
                  <a:effectLst/>
                </a:rPr>
                <a:t>for NAI susceptibility</a:t>
              </a:r>
            </a:p>
            <a:p>
              <a:pPr algn="ctr">
                <a:spcBef>
                  <a:spcPts val="1160"/>
                </a:spcBef>
              </a:pPr>
              <a:endParaRPr lang="en-US" sz="1850" dirty="0">
                <a:cs typeface="Times New Roman"/>
              </a:endParaRPr>
            </a:p>
            <a:p>
              <a:pPr>
                <a:spcBef>
                  <a:spcPts val="40"/>
                </a:spcBef>
              </a:pPr>
              <a:endParaRPr lang="en-US" sz="1850" dirty="0">
                <a:cs typeface="Times New Roman"/>
              </a:endParaRPr>
            </a:p>
            <a:p>
              <a:pPr>
                <a:spcBef>
                  <a:spcPts val="40"/>
                </a:spcBef>
              </a:pPr>
              <a:endParaRPr sz="1850" dirty="0">
                <a:cs typeface="Times New Roman"/>
              </a:endParaRPr>
            </a:p>
          </p:txBody>
        </p:sp>
        <p:sp>
          <p:nvSpPr>
            <p:cNvPr id="3" name="object 41">
              <a:extLst>
                <a:ext uri="{FF2B5EF4-FFF2-40B4-BE49-F238E27FC236}">
                  <a16:creationId xmlns:a16="http://schemas.microsoft.com/office/drawing/2014/main" id="{BBC288AD-31C5-4CCF-9F68-149A29C64CEC}"/>
                </a:ext>
              </a:extLst>
            </p:cNvPr>
            <p:cNvSpPr txBox="1"/>
            <p:nvPr/>
          </p:nvSpPr>
          <p:spPr>
            <a:xfrm>
              <a:off x="582434" y="2890133"/>
              <a:ext cx="1691548" cy="1287532"/>
            </a:xfrm>
            <a:prstGeom prst="rect">
              <a:avLst/>
            </a:prstGeom>
            <a:ln w="28956">
              <a:solidFill>
                <a:srgbClr val="000000"/>
              </a:solidFill>
            </a:ln>
          </p:spPr>
          <p:txBody>
            <a:bodyPr vert="horz" wrap="square" lIns="0" tIns="147320" rIns="0" bIns="0" rtlCol="0">
              <a:spAutoFit/>
            </a:bodyPr>
            <a:lstStyle/>
            <a:p>
              <a:pPr algn="ctr">
                <a:spcBef>
                  <a:spcPts val="1160"/>
                </a:spcBef>
              </a:pPr>
              <a:r>
                <a:rPr sz="2000" dirty="0">
                  <a:cs typeface="Calibri"/>
                </a:rPr>
                <a:t>n=</a:t>
              </a:r>
              <a:r>
                <a:rPr lang="en-US" sz="1800" b="1" i="0" u="none" strike="noStrike" dirty="0">
                  <a:solidFill>
                    <a:srgbClr val="000000"/>
                  </a:solidFill>
                  <a:effectLst/>
                </a:rPr>
                <a:t> </a:t>
              </a:r>
              <a:r>
                <a:rPr lang="en-US" b="1" dirty="0">
                  <a:solidFill>
                    <a:srgbClr val="000000"/>
                  </a:solidFill>
                </a:rPr>
                <a:t>26010</a:t>
              </a:r>
              <a:r>
                <a:rPr lang="en-US" sz="2000" dirty="0"/>
                <a:t> </a:t>
              </a:r>
              <a:endParaRPr sz="2000" dirty="0">
                <a:cs typeface="Calibri"/>
              </a:endParaRPr>
            </a:p>
            <a:p>
              <a:pPr marL="180340" marR="174625" algn="ctr"/>
              <a:r>
                <a:rPr spc="-10" dirty="0">
                  <a:cs typeface="Calibri"/>
                </a:rPr>
                <a:t>Influenza  </a:t>
              </a:r>
              <a:r>
                <a:rPr spc="-5" dirty="0">
                  <a:cs typeface="Calibri"/>
                </a:rPr>
                <a:t>viruses  analyzed</a:t>
              </a:r>
              <a:endParaRPr dirty="0">
                <a:cs typeface="Calibri"/>
              </a:endParaRPr>
            </a:p>
          </p:txBody>
        </p:sp>
        <p:sp>
          <p:nvSpPr>
            <p:cNvPr id="23" name="object 34">
              <a:extLst>
                <a:ext uri="{FF2B5EF4-FFF2-40B4-BE49-F238E27FC236}">
                  <a16:creationId xmlns:a16="http://schemas.microsoft.com/office/drawing/2014/main" id="{0DD8655C-FB2A-4A62-99B5-098C838D8995}"/>
                </a:ext>
              </a:extLst>
            </p:cNvPr>
            <p:cNvSpPr/>
            <p:nvPr/>
          </p:nvSpPr>
          <p:spPr>
            <a:xfrm>
              <a:off x="2979922" y="4954441"/>
              <a:ext cx="2561560" cy="1259444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rgbClr val="00FF99"/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1800" b="1" dirty="0">
                <a:cs typeface="Calibri"/>
              </a:endParaRPr>
            </a:p>
            <a:p>
              <a:pPr marL="12700" algn="ctr"/>
              <a:endParaRPr lang="en-US" sz="1800" dirty="0">
                <a:cs typeface="Calibri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7275A27-3195-490F-885D-CF56DF8EF48F}"/>
                </a:ext>
              </a:extLst>
            </p:cNvPr>
            <p:cNvSpPr txBox="1"/>
            <p:nvPr/>
          </p:nvSpPr>
          <p:spPr>
            <a:xfrm>
              <a:off x="3385400" y="1838485"/>
              <a:ext cx="191790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n=</a:t>
              </a:r>
              <a:r>
                <a:rPr lang="en-US" b="1" dirty="0"/>
                <a:t>11278 </a:t>
              </a:r>
              <a:r>
                <a:rPr lang="en-US" dirty="0"/>
                <a:t>viruses with NA sequences</a:t>
              </a:r>
            </a:p>
          </p:txBody>
        </p:sp>
        <p:sp>
          <p:nvSpPr>
            <p:cNvPr id="29" name="Rectangle: Rounded Corners 28">
              <a:extLst>
                <a:ext uri="{FF2B5EF4-FFF2-40B4-BE49-F238E27FC236}">
                  <a16:creationId xmlns:a16="http://schemas.microsoft.com/office/drawing/2014/main" id="{E3A6B980-8FC4-41B0-A817-55B8283370D1}"/>
                </a:ext>
              </a:extLst>
            </p:cNvPr>
            <p:cNvSpPr/>
            <p:nvPr/>
          </p:nvSpPr>
          <p:spPr>
            <a:xfrm>
              <a:off x="3353984" y="1892124"/>
              <a:ext cx="1917903" cy="823359"/>
            </a:xfrm>
            <a:prstGeom prst="roundRect">
              <a:avLst/>
            </a:prstGeom>
            <a:noFill/>
            <a:ln w="3810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8746F0A-301F-41CA-8224-A2686B1B27A9}"/>
                </a:ext>
              </a:extLst>
            </p:cNvPr>
            <p:cNvSpPr txBox="1"/>
            <p:nvPr/>
          </p:nvSpPr>
          <p:spPr>
            <a:xfrm>
              <a:off x="1305084" y="1444792"/>
              <a:ext cx="1667444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500" b="1" dirty="0">
                  <a:solidFill>
                    <a:schemeClr val="accent2">
                      <a:lumMod val="75000"/>
                    </a:schemeClr>
                  </a:solidFill>
                </a:rPr>
                <a:t>5 WHO CCs</a:t>
              </a:r>
            </a:p>
          </p:txBody>
        </p:sp>
        <p:cxnSp>
          <p:nvCxnSpPr>
            <p:cNvPr id="36" name="Connector: Elbow 35">
              <a:extLst>
                <a:ext uri="{FF2B5EF4-FFF2-40B4-BE49-F238E27FC236}">
                  <a16:creationId xmlns:a16="http://schemas.microsoft.com/office/drawing/2014/main" id="{B2D8933A-A8C4-40E6-AA09-6AE36D26CC52}"/>
                </a:ext>
              </a:extLst>
            </p:cNvPr>
            <p:cNvCxnSpPr>
              <a:cxnSpLocks/>
              <a:stCxn id="3" idx="0"/>
              <a:endCxn id="2" idx="1"/>
            </p:cNvCxnSpPr>
            <p:nvPr/>
          </p:nvCxnSpPr>
          <p:spPr>
            <a:xfrm rot="5400000" flipH="1" flipV="1">
              <a:off x="1739219" y="1619838"/>
              <a:ext cx="959285" cy="1581307"/>
            </a:xfrm>
            <a:prstGeom prst="bentConnector2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or: Elbow 40">
              <a:extLst>
                <a:ext uri="{FF2B5EF4-FFF2-40B4-BE49-F238E27FC236}">
                  <a16:creationId xmlns:a16="http://schemas.microsoft.com/office/drawing/2014/main" id="{869AA194-4582-4F11-900C-F20AB2578A4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529173" y="4092653"/>
              <a:ext cx="1371600" cy="1554480"/>
            </a:xfrm>
            <a:prstGeom prst="bentConnector2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3447139-F77E-4694-B747-82F9AD34753F}"/>
                </a:ext>
              </a:extLst>
            </p:cNvPr>
            <p:cNvSpPr txBox="1"/>
            <p:nvPr/>
          </p:nvSpPr>
          <p:spPr>
            <a:xfrm>
              <a:off x="1618711" y="5571441"/>
              <a:ext cx="1102481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500" b="1" dirty="0">
                  <a:solidFill>
                    <a:srgbClr val="0070C0"/>
                  </a:solidFill>
                </a:rPr>
                <a:t>GISAID</a:t>
              </a:r>
            </a:p>
          </p:txBody>
        </p:sp>
        <p:sp>
          <p:nvSpPr>
            <p:cNvPr id="32" name="object 34">
              <a:extLst>
                <a:ext uri="{FF2B5EF4-FFF2-40B4-BE49-F238E27FC236}">
                  <a16:creationId xmlns:a16="http://schemas.microsoft.com/office/drawing/2014/main" id="{B7A8193E-0132-4D16-B236-A47858799327}"/>
                </a:ext>
              </a:extLst>
            </p:cNvPr>
            <p:cNvSpPr/>
            <p:nvPr/>
          </p:nvSpPr>
          <p:spPr>
            <a:xfrm>
              <a:off x="3009515" y="3267568"/>
              <a:ext cx="2529035" cy="1205432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chemeClr val="bg1"/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2000" spc="-5" dirty="0">
                <a:solidFill>
                  <a:srgbClr val="0070C0"/>
                </a:solidFill>
                <a:cs typeface="Calibri"/>
              </a:endParaRPr>
            </a:p>
          </p:txBody>
        </p:sp>
        <p:sp>
          <p:nvSpPr>
            <p:cNvPr id="50" name="object 42">
              <a:extLst>
                <a:ext uri="{FF2B5EF4-FFF2-40B4-BE49-F238E27FC236}">
                  <a16:creationId xmlns:a16="http://schemas.microsoft.com/office/drawing/2014/main" id="{F553B57A-8DD4-499A-AF4C-E7DBE44725CE}"/>
                </a:ext>
              </a:extLst>
            </p:cNvPr>
            <p:cNvSpPr txBox="1"/>
            <p:nvPr/>
          </p:nvSpPr>
          <p:spPr>
            <a:xfrm>
              <a:off x="8294376" y="2919736"/>
              <a:ext cx="2042160" cy="1311898"/>
            </a:xfrm>
            <a:prstGeom prst="rect">
              <a:avLst/>
            </a:prstGeom>
            <a:ln w="28956">
              <a:solidFill>
                <a:srgbClr val="FF0000"/>
              </a:solidFill>
            </a:ln>
          </p:spPr>
          <p:txBody>
            <a:bodyPr vert="horz" wrap="square" lIns="0" tIns="6350" rIns="0" bIns="0" rtlCol="0">
              <a:spAutoFit/>
            </a:bodyPr>
            <a:lstStyle/>
            <a:p>
              <a:pPr algn="ctr">
                <a:spcBef>
                  <a:spcPts val="50"/>
                </a:spcBef>
              </a:pPr>
              <a:r>
                <a:rPr lang="en-US" b="1" dirty="0">
                  <a:solidFill>
                    <a:srgbClr val="FF0000"/>
                  </a:solidFill>
                  <a:cs typeface="Calibri"/>
                </a:rPr>
                <a:t>0.6</a:t>
              </a:r>
              <a:r>
                <a:rPr b="1" dirty="0">
                  <a:solidFill>
                    <a:srgbClr val="FF0000"/>
                  </a:solidFill>
                  <a:cs typeface="Calibri"/>
                </a:rPr>
                <a:t>%</a:t>
              </a:r>
              <a:r>
                <a:rPr b="1" spc="-90" dirty="0">
                  <a:solidFill>
                    <a:srgbClr val="FF0000"/>
                  </a:solidFill>
                  <a:cs typeface="Calibri"/>
                </a:rPr>
                <a:t> </a:t>
              </a:r>
              <a:endParaRPr lang="en-US" b="1" spc="-90" dirty="0">
                <a:solidFill>
                  <a:srgbClr val="FF0000"/>
                </a:solidFill>
                <a:cs typeface="Calibri"/>
              </a:endParaRPr>
            </a:p>
            <a:p>
              <a:pPr algn="ctr">
                <a:spcBef>
                  <a:spcPts val="50"/>
                </a:spcBef>
              </a:pPr>
              <a:r>
                <a:rPr b="1" dirty="0">
                  <a:solidFill>
                    <a:srgbClr val="FF0000"/>
                  </a:solidFill>
                  <a:cs typeface="Calibri"/>
                </a:rPr>
                <a:t>(n=</a:t>
              </a:r>
              <a:r>
                <a:rPr lang="en-US" b="1" dirty="0">
                  <a:solidFill>
                    <a:srgbClr val="FF0000"/>
                  </a:solidFill>
                  <a:cs typeface="Calibri"/>
                </a:rPr>
                <a:t>159/26010</a:t>
              </a:r>
              <a:r>
                <a:rPr b="1" dirty="0">
                  <a:solidFill>
                    <a:srgbClr val="FF0000"/>
                  </a:solidFill>
                  <a:cs typeface="Calibri"/>
                </a:rPr>
                <a:t>)</a:t>
              </a:r>
              <a:endParaRPr dirty="0">
                <a:cs typeface="Calibri"/>
              </a:endParaRPr>
            </a:p>
            <a:p>
              <a:pPr marL="185420" marR="177165" algn="ctr">
                <a:spcBef>
                  <a:spcPts val="5"/>
                </a:spcBef>
              </a:pPr>
              <a:r>
                <a:rPr lang="en-US" sz="1600" spc="-10" dirty="0">
                  <a:solidFill>
                    <a:srgbClr val="FF0000"/>
                  </a:solidFill>
                  <a:cs typeface="Calibri"/>
                </a:rPr>
                <a:t>global</a:t>
              </a:r>
              <a:r>
                <a:rPr sz="1600" spc="-10" dirty="0">
                  <a:solidFill>
                    <a:srgbClr val="FF0000"/>
                  </a:solidFill>
                  <a:cs typeface="Calibri"/>
                </a:rPr>
                <a:t> </a:t>
              </a:r>
              <a:r>
                <a:rPr sz="1600" spc="-5" dirty="0">
                  <a:solidFill>
                    <a:srgbClr val="FF0000"/>
                  </a:solidFill>
                  <a:cs typeface="Calibri"/>
                </a:rPr>
                <a:t>frequency  of</a:t>
              </a:r>
              <a:r>
                <a:rPr sz="1600" spc="-75" dirty="0">
                  <a:solidFill>
                    <a:srgbClr val="FF0000"/>
                  </a:solidFill>
                  <a:cs typeface="Calibri"/>
                </a:rPr>
                <a:t> </a:t>
              </a:r>
              <a:r>
                <a:rPr lang="en-US" sz="1600" spc="-5" dirty="0">
                  <a:solidFill>
                    <a:srgbClr val="FF0000"/>
                  </a:solidFill>
                  <a:cs typeface="Calibri"/>
                </a:rPr>
                <a:t>RI/HRI based on markers</a:t>
              </a:r>
              <a:endParaRPr sz="1600" dirty="0">
                <a:cs typeface="Calibri"/>
              </a:endParaRPr>
            </a:p>
          </p:txBody>
        </p:sp>
        <p:sp>
          <p:nvSpPr>
            <p:cNvPr id="59" name="object 6">
              <a:extLst>
                <a:ext uri="{FF2B5EF4-FFF2-40B4-BE49-F238E27FC236}">
                  <a16:creationId xmlns:a16="http://schemas.microsoft.com/office/drawing/2014/main" id="{0839B475-5CA0-4395-9588-2EAA554777F0}"/>
                </a:ext>
              </a:extLst>
            </p:cNvPr>
            <p:cNvSpPr txBox="1"/>
            <p:nvPr/>
          </p:nvSpPr>
          <p:spPr>
            <a:xfrm>
              <a:off x="5877351" y="919807"/>
              <a:ext cx="1458456" cy="70788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9685" algn="ctr"/>
              <a:r>
                <a:rPr spc="-5" dirty="0">
                  <a:cs typeface="Calibri"/>
                </a:rPr>
                <a:t>n=</a:t>
              </a:r>
              <a:r>
                <a:rPr lang="en-US" b="1" spc="-5" dirty="0">
                  <a:cs typeface="Calibri"/>
                </a:rPr>
                <a:t>9853</a:t>
              </a:r>
              <a:endParaRPr lang="en-US" b="1" dirty="0">
                <a:cs typeface="Calibri"/>
              </a:endParaRPr>
            </a:p>
            <a:p>
              <a:pPr marL="12700" marR="5080" indent="30480" algn="ctr"/>
              <a:r>
                <a:rPr lang="en-US" sz="1400" spc="-35" dirty="0">
                  <a:cs typeface="Calibri"/>
                </a:rPr>
                <a:t>t</a:t>
              </a:r>
              <a:r>
                <a:rPr sz="1400" spc="-35" dirty="0">
                  <a:cs typeface="Calibri"/>
                </a:rPr>
                <a:t>ested </a:t>
              </a:r>
              <a:r>
                <a:rPr sz="1400" dirty="0">
                  <a:cs typeface="Calibri"/>
                </a:rPr>
                <a:t>in</a:t>
              </a:r>
              <a:r>
                <a:rPr lang="en-US" sz="1400" dirty="0">
                  <a:cs typeface="Calibri"/>
                </a:rPr>
                <a:t> NA inhibition assay</a:t>
              </a:r>
              <a:endParaRPr sz="1400" dirty="0">
                <a:cs typeface="Calibri"/>
              </a:endParaRPr>
            </a:p>
          </p:txBody>
        </p:sp>
        <p:sp>
          <p:nvSpPr>
            <p:cNvPr id="69" name="object 29">
              <a:extLst>
                <a:ext uri="{FF2B5EF4-FFF2-40B4-BE49-F238E27FC236}">
                  <a16:creationId xmlns:a16="http://schemas.microsoft.com/office/drawing/2014/main" id="{14F28E5E-8624-4210-8BAD-D6E7A77ABFE7}"/>
                </a:ext>
              </a:extLst>
            </p:cNvPr>
            <p:cNvSpPr/>
            <p:nvPr/>
          </p:nvSpPr>
          <p:spPr>
            <a:xfrm>
              <a:off x="5900393" y="1648556"/>
              <a:ext cx="1318892" cy="457200"/>
            </a:xfrm>
            <a:custGeom>
              <a:avLst/>
              <a:gdLst/>
              <a:ahLst/>
              <a:cxnLst/>
              <a:rect l="l" t="t" r="r" b="b"/>
              <a:pathLst>
                <a:path w="1303020" h="562610">
                  <a:moveTo>
                    <a:pt x="0" y="93726"/>
                  </a:moveTo>
                  <a:lnTo>
                    <a:pt x="7358" y="57221"/>
                  </a:lnTo>
                  <a:lnTo>
                    <a:pt x="27431" y="27431"/>
                  </a:lnTo>
                  <a:lnTo>
                    <a:pt x="57221" y="7358"/>
                  </a:lnTo>
                  <a:lnTo>
                    <a:pt x="93725" y="0"/>
                  </a:lnTo>
                  <a:lnTo>
                    <a:pt x="1209294" y="0"/>
                  </a:lnTo>
                  <a:lnTo>
                    <a:pt x="1245798" y="7358"/>
                  </a:lnTo>
                  <a:lnTo>
                    <a:pt x="1275587" y="27432"/>
                  </a:lnTo>
                  <a:lnTo>
                    <a:pt x="1295661" y="57221"/>
                  </a:lnTo>
                  <a:lnTo>
                    <a:pt x="1303020" y="93726"/>
                  </a:lnTo>
                  <a:lnTo>
                    <a:pt x="1303020" y="468630"/>
                  </a:lnTo>
                  <a:lnTo>
                    <a:pt x="1295661" y="505134"/>
                  </a:lnTo>
                  <a:lnTo>
                    <a:pt x="1275587" y="534924"/>
                  </a:lnTo>
                  <a:lnTo>
                    <a:pt x="1245798" y="554997"/>
                  </a:lnTo>
                  <a:lnTo>
                    <a:pt x="1209294" y="562356"/>
                  </a:lnTo>
                  <a:lnTo>
                    <a:pt x="93725" y="562356"/>
                  </a:lnTo>
                  <a:lnTo>
                    <a:pt x="57221" y="554997"/>
                  </a:lnTo>
                  <a:lnTo>
                    <a:pt x="27431" y="534924"/>
                  </a:lnTo>
                  <a:lnTo>
                    <a:pt x="7358" y="505134"/>
                  </a:lnTo>
                  <a:lnTo>
                    <a:pt x="0" y="468630"/>
                  </a:lnTo>
                  <a:lnTo>
                    <a:pt x="0" y="93726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8956">
              <a:solidFill>
                <a:srgbClr val="006FC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30">
              <a:extLst>
                <a:ext uri="{FF2B5EF4-FFF2-40B4-BE49-F238E27FC236}">
                  <a16:creationId xmlns:a16="http://schemas.microsoft.com/office/drawing/2014/main" id="{152F0C61-C777-478F-96B0-5F6926D6D37E}"/>
                </a:ext>
              </a:extLst>
            </p:cNvPr>
            <p:cNvSpPr txBox="1"/>
            <p:nvPr/>
          </p:nvSpPr>
          <p:spPr>
            <a:xfrm>
              <a:off x="6175794" y="1772554"/>
              <a:ext cx="924688" cy="246221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/>
              <a:r>
                <a:rPr sz="1600" b="1" dirty="0">
                  <a:cs typeface="Calibri"/>
                </a:rPr>
                <a:t>n=</a:t>
              </a:r>
              <a:r>
                <a:rPr lang="en-US" sz="1600" b="1" dirty="0">
                  <a:cs typeface="Calibri"/>
                </a:rPr>
                <a:t> 5549</a:t>
              </a:r>
              <a:endParaRPr sz="1600" dirty="0">
                <a:cs typeface="Calibri"/>
              </a:endParaRPr>
            </a:p>
          </p:txBody>
        </p:sp>
        <p:sp>
          <p:nvSpPr>
            <p:cNvPr id="72" name="object 16">
              <a:extLst>
                <a:ext uri="{FF2B5EF4-FFF2-40B4-BE49-F238E27FC236}">
                  <a16:creationId xmlns:a16="http://schemas.microsoft.com/office/drawing/2014/main" id="{8523F57B-62BB-4243-9D86-9C3D69814FF5}"/>
                </a:ext>
              </a:extLst>
            </p:cNvPr>
            <p:cNvSpPr/>
            <p:nvPr/>
          </p:nvSpPr>
          <p:spPr>
            <a:xfrm>
              <a:off x="8207313" y="1114736"/>
              <a:ext cx="1655606" cy="1175617"/>
            </a:xfrm>
            <a:custGeom>
              <a:avLst/>
              <a:gdLst/>
              <a:ahLst/>
              <a:cxnLst/>
              <a:rect l="l" t="t" r="r" b="b"/>
              <a:pathLst>
                <a:path w="1551939" h="685800">
                  <a:moveTo>
                    <a:pt x="1437131" y="0"/>
                  </a:moveTo>
                  <a:lnTo>
                    <a:pt x="114300" y="0"/>
                  </a:lnTo>
                  <a:lnTo>
                    <a:pt x="69812" y="8983"/>
                  </a:lnTo>
                  <a:lnTo>
                    <a:pt x="33480" y="33480"/>
                  </a:lnTo>
                  <a:lnTo>
                    <a:pt x="8983" y="69812"/>
                  </a:lnTo>
                  <a:lnTo>
                    <a:pt x="0" y="114300"/>
                  </a:lnTo>
                  <a:lnTo>
                    <a:pt x="0" y="571500"/>
                  </a:lnTo>
                  <a:lnTo>
                    <a:pt x="8983" y="615987"/>
                  </a:lnTo>
                  <a:lnTo>
                    <a:pt x="33480" y="652319"/>
                  </a:lnTo>
                  <a:lnTo>
                    <a:pt x="69812" y="676816"/>
                  </a:lnTo>
                  <a:lnTo>
                    <a:pt x="114300" y="685800"/>
                  </a:lnTo>
                  <a:lnTo>
                    <a:pt x="1437131" y="685800"/>
                  </a:lnTo>
                  <a:lnTo>
                    <a:pt x="1481619" y="676816"/>
                  </a:lnTo>
                  <a:lnTo>
                    <a:pt x="1517951" y="652319"/>
                  </a:lnTo>
                  <a:lnTo>
                    <a:pt x="1542448" y="615987"/>
                  </a:lnTo>
                  <a:lnTo>
                    <a:pt x="1551431" y="571500"/>
                  </a:lnTo>
                  <a:lnTo>
                    <a:pt x="1551431" y="114300"/>
                  </a:lnTo>
                  <a:lnTo>
                    <a:pt x="1542448" y="69812"/>
                  </a:lnTo>
                  <a:lnTo>
                    <a:pt x="1517951" y="33480"/>
                  </a:lnTo>
                  <a:lnTo>
                    <a:pt x="1481619" y="8983"/>
                  </a:lnTo>
                  <a:lnTo>
                    <a:pt x="1437131" y="0"/>
                  </a:ln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25400">
              <a:solidFill>
                <a:schemeClr val="accent2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18">
              <a:extLst>
                <a:ext uri="{FF2B5EF4-FFF2-40B4-BE49-F238E27FC236}">
                  <a16:creationId xmlns:a16="http://schemas.microsoft.com/office/drawing/2014/main" id="{72D68181-E5B9-4A12-88E1-CD2E553DD777}"/>
                </a:ext>
              </a:extLst>
            </p:cNvPr>
            <p:cNvSpPr txBox="1"/>
            <p:nvPr/>
          </p:nvSpPr>
          <p:spPr>
            <a:xfrm>
              <a:off x="8262608" y="1127542"/>
              <a:ext cx="1600311" cy="1138773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" algn="ctr"/>
              <a:r>
                <a:rPr dirty="0">
                  <a:cs typeface="Calibri"/>
                </a:rPr>
                <a:t>n=</a:t>
              </a:r>
              <a:r>
                <a:rPr lang="en-US" dirty="0">
                  <a:cs typeface="Calibri"/>
                </a:rPr>
                <a:t> </a:t>
              </a:r>
              <a:r>
                <a:rPr lang="en-US" b="1" dirty="0">
                  <a:cs typeface="Calibri"/>
                </a:rPr>
                <a:t>96</a:t>
              </a:r>
              <a:r>
                <a:rPr lang="en-US" spc="-95" dirty="0">
                  <a:cs typeface="Calibri"/>
                </a:rPr>
                <a:t> </a:t>
              </a:r>
            </a:p>
            <a:p>
              <a:pPr marL="1270" algn="ctr"/>
              <a:r>
                <a:rPr lang="en-US" sz="1400" spc="-95" dirty="0">
                  <a:cs typeface="Calibri"/>
                </a:rPr>
                <a:t>with markers</a:t>
              </a:r>
              <a:endParaRPr sz="1400" dirty="0">
                <a:cs typeface="Calibri"/>
              </a:endParaRPr>
            </a:p>
            <a:p>
              <a:pPr algn="ctr">
                <a:lnSpc>
                  <a:spcPct val="100000"/>
                </a:lnSpc>
              </a:pPr>
              <a:r>
                <a:rPr sz="1400" dirty="0">
                  <a:cs typeface="Calibri"/>
                </a:rPr>
                <a:t>&amp;</a:t>
              </a:r>
              <a:endParaRPr lang="en-US" sz="1400" dirty="0">
                <a:cs typeface="Calibri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1400" b="1" dirty="0">
                  <a:cs typeface="Calibri"/>
                </a:rPr>
                <a:t>RI/HRI </a:t>
              </a:r>
              <a:r>
                <a:rPr lang="en-US" sz="1400" dirty="0">
                  <a:cs typeface="Calibri"/>
                </a:rPr>
                <a:t>in NA inhibition assay</a:t>
              </a:r>
            </a:p>
          </p:txBody>
        </p:sp>
        <p:sp>
          <p:nvSpPr>
            <p:cNvPr id="80" name="Arrow: Right 79">
              <a:extLst>
                <a:ext uri="{FF2B5EF4-FFF2-40B4-BE49-F238E27FC236}">
                  <a16:creationId xmlns:a16="http://schemas.microsoft.com/office/drawing/2014/main" id="{EED4FEC6-3793-4465-AAE6-9B37E305F78C}"/>
                </a:ext>
              </a:extLst>
            </p:cNvPr>
            <p:cNvSpPr/>
            <p:nvPr/>
          </p:nvSpPr>
          <p:spPr>
            <a:xfrm>
              <a:off x="5549193" y="5364673"/>
              <a:ext cx="1420654" cy="301752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object 23">
              <a:extLst>
                <a:ext uri="{FF2B5EF4-FFF2-40B4-BE49-F238E27FC236}">
                  <a16:creationId xmlns:a16="http://schemas.microsoft.com/office/drawing/2014/main" id="{62322166-203F-423C-A303-6B7A22D466E1}"/>
                </a:ext>
              </a:extLst>
            </p:cNvPr>
            <p:cNvSpPr/>
            <p:nvPr/>
          </p:nvSpPr>
          <p:spPr>
            <a:xfrm>
              <a:off x="5758208" y="1843484"/>
              <a:ext cx="148455" cy="913435"/>
            </a:xfrm>
            <a:custGeom>
              <a:avLst/>
              <a:gdLst/>
              <a:ahLst/>
              <a:cxnLst/>
              <a:rect l="l" t="t" r="r" b="b"/>
              <a:pathLst>
                <a:path w="346075" h="2153920">
                  <a:moveTo>
                    <a:pt x="345947" y="2153412"/>
                  </a:moveTo>
                  <a:lnTo>
                    <a:pt x="211312" y="2153412"/>
                  </a:lnTo>
                  <a:lnTo>
                    <a:pt x="101345" y="2153412"/>
                  </a:lnTo>
                  <a:lnTo>
                    <a:pt x="27193" y="2153412"/>
                  </a:lnTo>
                  <a:lnTo>
                    <a:pt x="0" y="2153412"/>
                  </a:lnTo>
                  <a:lnTo>
                    <a:pt x="0" y="0"/>
                  </a:lnTo>
                  <a:lnTo>
                    <a:pt x="27193" y="0"/>
                  </a:lnTo>
                  <a:lnTo>
                    <a:pt x="101345" y="0"/>
                  </a:lnTo>
                  <a:lnTo>
                    <a:pt x="211312" y="0"/>
                  </a:lnTo>
                  <a:lnTo>
                    <a:pt x="345947" y="0"/>
                  </a:lnTo>
                </a:path>
              </a:pathLst>
            </a:custGeom>
            <a:ln w="28956">
              <a:solidFill>
                <a:srgbClr val="006FC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34">
              <a:extLst>
                <a:ext uri="{FF2B5EF4-FFF2-40B4-BE49-F238E27FC236}">
                  <a16:creationId xmlns:a16="http://schemas.microsoft.com/office/drawing/2014/main" id="{096298BB-21BA-421B-A0E3-C609479CB7E3}"/>
                </a:ext>
              </a:extLst>
            </p:cNvPr>
            <p:cNvSpPr/>
            <p:nvPr/>
          </p:nvSpPr>
          <p:spPr>
            <a:xfrm>
              <a:off x="5870376" y="2392079"/>
              <a:ext cx="1873662" cy="1046615"/>
            </a:xfrm>
            <a:custGeom>
              <a:avLst/>
              <a:gdLst/>
              <a:ahLst/>
              <a:cxnLst/>
              <a:rect l="l" t="t" r="r" b="b"/>
              <a:pathLst>
                <a:path w="1434464" h="995679">
                  <a:moveTo>
                    <a:pt x="0" y="165862"/>
                  </a:moveTo>
                  <a:lnTo>
                    <a:pt x="5927" y="121781"/>
                  </a:lnTo>
                  <a:lnTo>
                    <a:pt x="22653" y="82164"/>
                  </a:lnTo>
                  <a:lnTo>
                    <a:pt x="48593" y="48593"/>
                  </a:lnTo>
                  <a:lnTo>
                    <a:pt x="82164" y="22653"/>
                  </a:lnTo>
                  <a:lnTo>
                    <a:pt x="121781" y="5927"/>
                  </a:lnTo>
                  <a:lnTo>
                    <a:pt x="165862" y="0"/>
                  </a:lnTo>
                  <a:lnTo>
                    <a:pt x="1268222" y="0"/>
                  </a:lnTo>
                  <a:lnTo>
                    <a:pt x="1312302" y="5927"/>
                  </a:lnTo>
                  <a:lnTo>
                    <a:pt x="1351919" y="22653"/>
                  </a:lnTo>
                  <a:lnTo>
                    <a:pt x="1385490" y="48593"/>
                  </a:lnTo>
                  <a:lnTo>
                    <a:pt x="1411430" y="82164"/>
                  </a:lnTo>
                  <a:lnTo>
                    <a:pt x="1428156" y="121781"/>
                  </a:lnTo>
                  <a:lnTo>
                    <a:pt x="1434084" y="165862"/>
                  </a:lnTo>
                  <a:lnTo>
                    <a:pt x="1434084" y="829310"/>
                  </a:lnTo>
                  <a:lnTo>
                    <a:pt x="1428156" y="873390"/>
                  </a:lnTo>
                  <a:lnTo>
                    <a:pt x="1411430" y="913007"/>
                  </a:lnTo>
                  <a:lnTo>
                    <a:pt x="1385490" y="946578"/>
                  </a:lnTo>
                  <a:lnTo>
                    <a:pt x="1351919" y="972518"/>
                  </a:lnTo>
                  <a:lnTo>
                    <a:pt x="1312302" y="989244"/>
                  </a:lnTo>
                  <a:lnTo>
                    <a:pt x="1268222" y="995171"/>
                  </a:lnTo>
                  <a:lnTo>
                    <a:pt x="165862" y="995171"/>
                  </a:lnTo>
                  <a:lnTo>
                    <a:pt x="121781" y="989244"/>
                  </a:lnTo>
                  <a:lnTo>
                    <a:pt x="82164" y="972518"/>
                  </a:lnTo>
                  <a:lnTo>
                    <a:pt x="48593" y="946578"/>
                  </a:lnTo>
                  <a:lnTo>
                    <a:pt x="22653" y="913007"/>
                  </a:lnTo>
                  <a:lnTo>
                    <a:pt x="5927" y="873390"/>
                  </a:lnTo>
                  <a:lnTo>
                    <a:pt x="0" y="829310"/>
                  </a:lnTo>
                  <a:lnTo>
                    <a:pt x="0" y="165862"/>
                  </a:lnTo>
                  <a:close/>
                </a:path>
              </a:pathLst>
            </a:custGeom>
            <a:solidFill>
              <a:schemeClr val="accent4">
                <a:lumMod val="40000"/>
                <a:lumOff val="60000"/>
              </a:schemeClr>
            </a:solidFill>
            <a:ln w="28956">
              <a:solidFill>
                <a:srgbClr val="0070C0"/>
              </a:solidFill>
            </a:ln>
          </p:spPr>
          <p:txBody>
            <a:bodyPr wrap="square" lIns="0" tIns="0" rIns="0" bIns="0" rtlCol="0"/>
            <a:lstStyle/>
            <a:p>
              <a:pPr marL="12700" algn="ctr"/>
              <a:endParaRPr lang="en-US" sz="1400" b="1" dirty="0">
                <a:cs typeface="Calibri"/>
              </a:endParaRPr>
            </a:p>
          </p:txBody>
        </p:sp>
        <p:sp>
          <p:nvSpPr>
            <p:cNvPr id="8" name="object 13">
              <a:extLst>
                <a:ext uri="{FF2B5EF4-FFF2-40B4-BE49-F238E27FC236}">
                  <a16:creationId xmlns:a16="http://schemas.microsoft.com/office/drawing/2014/main" id="{6BA6322E-912A-4AC6-96F6-04E6478E9861}"/>
                </a:ext>
              </a:extLst>
            </p:cNvPr>
            <p:cNvSpPr/>
            <p:nvPr/>
          </p:nvSpPr>
          <p:spPr>
            <a:xfrm>
              <a:off x="7004398" y="5085076"/>
              <a:ext cx="1818356" cy="907650"/>
            </a:xfrm>
            <a:custGeom>
              <a:avLst/>
              <a:gdLst/>
              <a:ahLst/>
              <a:cxnLst/>
              <a:rect l="l" t="t" r="r" b="b"/>
              <a:pathLst>
                <a:path w="1407160" h="609600">
                  <a:moveTo>
                    <a:pt x="1305052" y="0"/>
                  </a:moveTo>
                  <a:lnTo>
                    <a:pt x="101600" y="0"/>
                  </a:lnTo>
                  <a:lnTo>
                    <a:pt x="62043" y="7981"/>
                  </a:lnTo>
                  <a:lnTo>
                    <a:pt x="29749" y="29749"/>
                  </a:lnTo>
                  <a:lnTo>
                    <a:pt x="7981" y="62043"/>
                  </a:lnTo>
                  <a:lnTo>
                    <a:pt x="0" y="101599"/>
                  </a:lnTo>
                  <a:lnTo>
                    <a:pt x="0" y="507999"/>
                  </a:lnTo>
                  <a:lnTo>
                    <a:pt x="7981" y="547556"/>
                  </a:lnTo>
                  <a:lnTo>
                    <a:pt x="29749" y="579850"/>
                  </a:lnTo>
                  <a:lnTo>
                    <a:pt x="62043" y="601618"/>
                  </a:lnTo>
                  <a:lnTo>
                    <a:pt x="101600" y="609599"/>
                  </a:lnTo>
                  <a:lnTo>
                    <a:pt x="1305052" y="609599"/>
                  </a:lnTo>
                  <a:lnTo>
                    <a:pt x="1344608" y="601618"/>
                  </a:lnTo>
                  <a:lnTo>
                    <a:pt x="1376902" y="579850"/>
                  </a:lnTo>
                  <a:lnTo>
                    <a:pt x="1398670" y="547556"/>
                  </a:lnTo>
                  <a:lnTo>
                    <a:pt x="1406652" y="507999"/>
                  </a:lnTo>
                  <a:lnTo>
                    <a:pt x="1406652" y="101599"/>
                  </a:lnTo>
                  <a:lnTo>
                    <a:pt x="1398670" y="62043"/>
                  </a:lnTo>
                  <a:lnTo>
                    <a:pt x="1376902" y="29749"/>
                  </a:lnTo>
                  <a:lnTo>
                    <a:pt x="1344608" y="7981"/>
                  </a:lnTo>
                  <a:lnTo>
                    <a:pt x="1305052" y="0"/>
                  </a:lnTo>
                  <a:close/>
                </a:path>
              </a:pathLst>
            </a:custGeom>
            <a:solidFill>
              <a:srgbClr val="00FF99"/>
            </a:solidFill>
            <a:ln>
              <a:solidFill>
                <a:schemeClr val="accent1"/>
              </a:solidFill>
            </a:ln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9" name="object 14">
              <a:extLst>
                <a:ext uri="{FF2B5EF4-FFF2-40B4-BE49-F238E27FC236}">
                  <a16:creationId xmlns:a16="http://schemas.microsoft.com/office/drawing/2014/main" id="{D9BEC6EB-DB02-43A4-8EB3-260DC4A34733}"/>
                </a:ext>
              </a:extLst>
            </p:cNvPr>
            <p:cNvSpPr/>
            <p:nvPr/>
          </p:nvSpPr>
          <p:spPr>
            <a:xfrm>
              <a:off x="7004398" y="5085665"/>
              <a:ext cx="1818356" cy="907650"/>
            </a:xfrm>
            <a:custGeom>
              <a:avLst/>
              <a:gdLst/>
              <a:ahLst/>
              <a:cxnLst/>
              <a:rect l="l" t="t" r="r" b="b"/>
              <a:pathLst>
                <a:path w="1407160" h="609600">
                  <a:moveTo>
                    <a:pt x="0" y="101599"/>
                  </a:moveTo>
                  <a:lnTo>
                    <a:pt x="7981" y="62043"/>
                  </a:lnTo>
                  <a:lnTo>
                    <a:pt x="29749" y="29749"/>
                  </a:lnTo>
                  <a:lnTo>
                    <a:pt x="62043" y="7981"/>
                  </a:lnTo>
                  <a:lnTo>
                    <a:pt x="101600" y="0"/>
                  </a:lnTo>
                  <a:lnTo>
                    <a:pt x="1305052" y="0"/>
                  </a:lnTo>
                  <a:lnTo>
                    <a:pt x="1344608" y="7981"/>
                  </a:lnTo>
                  <a:lnTo>
                    <a:pt x="1376902" y="29749"/>
                  </a:lnTo>
                  <a:lnTo>
                    <a:pt x="1398670" y="62043"/>
                  </a:lnTo>
                  <a:lnTo>
                    <a:pt x="1406652" y="101599"/>
                  </a:lnTo>
                  <a:lnTo>
                    <a:pt x="1406652" y="507999"/>
                  </a:lnTo>
                  <a:lnTo>
                    <a:pt x="1398670" y="547556"/>
                  </a:lnTo>
                  <a:lnTo>
                    <a:pt x="1376902" y="579850"/>
                  </a:lnTo>
                  <a:lnTo>
                    <a:pt x="1344608" y="601618"/>
                  </a:lnTo>
                  <a:lnTo>
                    <a:pt x="1305052" y="609599"/>
                  </a:lnTo>
                  <a:lnTo>
                    <a:pt x="101600" y="609599"/>
                  </a:lnTo>
                  <a:lnTo>
                    <a:pt x="62043" y="601618"/>
                  </a:lnTo>
                  <a:lnTo>
                    <a:pt x="29749" y="579850"/>
                  </a:lnTo>
                  <a:lnTo>
                    <a:pt x="7981" y="547556"/>
                  </a:lnTo>
                  <a:lnTo>
                    <a:pt x="0" y="507999"/>
                  </a:lnTo>
                  <a:lnTo>
                    <a:pt x="0" y="101599"/>
                  </a:lnTo>
                  <a:close/>
                </a:path>
              </a:pathLst>
            </a:custGeom>
            <a:solidFill>
              <a:srgbClr val="00FF99"/>
            </a:solidFill>
            <a:ln w="28575">
              <a:solidFill>
                <a:schemeClr val="accent1"/>
              </a:solidFill>
            </a:ln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0" name="object 15">
              <a:extLst>
                <a:ext uri="{FF2B5EF4-FFF2-40B4-BE49-F238E27FC236}">
                  <a16:creationId xmlns:a16="http://schemas.microsoft.com/office/drawing/2014/main" id="{B1C92DF9-0F49-4861-99C4-A9453B3E3C12}"/>
                </a:ext>
              </a:extLst>
            </p:cNvPr>
            <p:cNvSpPr txBox="1"/>
            <p:nvPr/>
          </p:nvSpPr>
          <p:spPr>
            <a:xfrm>
              <a:off x="7373348" y="5201750"/>
              <a:ext cx="1152884" cy="707886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0" tIns="0" rIns="0" bIns="0" rtlCol="0">
              <a:spAutoFit/>
            </a:bodyPr>
            <a:lstStyle/>
            <a:p>
              <a:pPr marL="1270" algn="ctr"/>
              <a:r>
                <a:rPr spc="-5" dirty="0">
                  <a:cs typeface="Calibri"/>
                </a:rPr>
                <a:t>n=</a:t>
              </a:r>
              <a:r>
                <a:rPr lang="en-US" b="1" spc="-5" dirty="0">
                  <a:cs typeface="Calibri"/>
                </a:rPr>
                <a:t>63</a:t>
              </a:r>
              <a:endParaRPr dirty="0">
                <a:cs typeface="Calibri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1400" dirty="0">
                  <a:cs typeface="Calibri"/>
                </a:rPr>
                <a:t>with </a:t>
              </a:r>
              <a:r>
                <a:rPr lang="en-US" sz="1400" b="1" dirty="0">
                  <a:cs typeface="Calibri"/>
                </a:rPr>
                <a:t>RI/HRI </a:t>
              </a:r>
              <a:r>
                <a:rPr lang="en-US" sz="1400" dirty="0">
                  <a:cs typeface="Calibri"/>
                </a:rPr>
                <a:t>marker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A80227E-B68A-4743-AAF4-0DB26BBDE58C}"/>
                </a:ext>
              </a:extLst>
            </p:cNvPr>
            <p:cNvSpPr txBox="1"/>
            <p:nvPr/>
          </p:nvSpPr>
          <p:spPr>
            <a:xfrm>
              <a:off x="3221727" y="3414711"/>
              <a:ext cx="2147580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sz="1800" dirty="0">
                  <a:cs typeface="Calibri"/>
                </a:rPr>
                <a:t>n</a:t>
              </a:r>
              <a:r>
                <a:rPr lang="en-US" sz="1800" spc="-5" dirty="0">
                  <a:cs typeface="Calibri"/>
                </a:rPr>
                <a:t>= </a:t>
              </a:r>
              <a:r>
                <a:rPr lang="en-US" b="1" spc="-5" dirty="0">
                  <a:cs typeface="Calibri"/>
                </a:rPr>
                <a:t>21706</a:t>
              </a:r>
              <a:r>
                <a:rPr lang="en-US" sz="1800" b="1" spc="-5" dirty="0">
                  <a:cs typeface="Calibri"/>
                </a:rPr>
                <a:t> </a:t>
              </a:r>
              <a:r>
                <a:rPr lang="en-US" sz="1800" spc="-5" dirty="0">
                  <a:cs typeface="Calibri"/>
                </a:rPr>
                <a:t>viruses</a:t>
              </a:r>
            </a:p>
            <a:p>
              <a:pPr marL="12700" algn="ctr"/>
              <a:r>
                <a:rPr lang="en-US" sz="1800" dirty="0">
                  <a:cs typeface="Calibri"/>
                </a:rPr>
                <a:t>with NA </a:t>
              </a:r>
              <a:r>
                <a:rPr lang="en-US" sz="1800" spc="-5" dirty="0">
                  <a:cs typeface="Calibri"/>
                </a:rPr>
                <a:t>sequences</a:t>
              </a:r>
              <a:r>
                <a:rPr lang="en-US" sz="1800" spc="-60" dirty="0">
                  <a:cs typeface="Calibri"/>
                </a:rPr>
                <a:t> </a:t>
              </a:r>
              <a:r>
                <a:rPr lang="en-US" sz="1800" b="1" dirty="0">
                  <a:cs typeface="Calibri"/>
                </a:rPr>
                <a:t>in  </a:t>
              </a:r>
              <a:r>
                <a:rPr lang="en-US" sz="1800" b="1" spc="-5" dirty="0">
                  <a:cs typeface="Calibri"/>
                </a:rPr>
                <a:t>GISAID</a:t>
              </a:r>
            </a:p>
          </p:txBody>
        </p:sp>
        <p:sp>
          <p:nvSpPr>
            <p:cNvPr id="12" name="Arrow: Right 11">
              <a:extLst>
                <a:ext uri="{FF2B5EF4-FFF2-40B4-BE49-F238E27FC236}">
                  <a16:creationId xmlns:a16="http://schemas.microsoft.com/office/drawing/2014/main" id="{9C422631-B367-46F2-99A5-E31BF2F320BC}"/>
                </a:ext>
              </a:extLst>
            </p:cNvPr>
            <p:cNvSpPr/>
            <p:nvPr/>
          </p:nvSpPr>
          <p:spPr>
            <a:xfrm rot="16200000">
              <a:off x="4092073" y="2884749"/>
              <a:ext cx="424014" cy="341624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row: Right 42">
              <a:extLst>
                <a:ext uri="{FF2B5EF4-FFF2-40B4-BE49-F238E27FC236}">
                  <a16:creationId xmlns:a16="http://schemas.microsoft.com/office/drawing/2014/main" id="{E32B6613-6CF0-4F99-8D53-E28A246292D5}"/>
                </a:ext>
              </a:extLst>
            </p:cNvPr>
            <p:cNvSpPr/>
            <p:nvPr/>
          </p:nvSpPr>
          <p:spPr>
            <a:xfrm rot="5400000" flipV="1">
              <a:off x="4054840" y="4514195"/>
              <a:ext cx="424014" cy="341624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0BA1FA0-A1BA-4575-8D9C-681845EF6E81}"/>
                </a:ext>
              </a:extLst>
            </p:cNvPr>
            <p:cNvSpPr txBox="1"/>
            <p:nvPr/>
          </p:nvSpPr>
          <p:spPr>
            <a:xfrm>
              <a:off x="2902171" y="4939326"/>
              <a:ext cx="2688738" cy="110799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sz="1800" dirty="0">
                  <a:cs typeface="Calibri"/>
                </a:rPr>
                <a:t>n</a:t>
              </a:r>
              <a:r>
                <a:rPr lang="en-US" sz="1800" spc="-5" dirty="0">
                  <a:cs typeface="Calibri"/>
                </a:rPr>
                <a:t>= </a:t>
              </a:r>
              <a:r>
                <a:rPr lang="en-US" b="1" spc="-5" dirty="0">
                  <a:cs typeface="Calibri"/>
                </a:rPr>
                <a:t>10428</a:t>
              </a:r>
            </a:p>
            <a:p>
              <a:pPr marL="12700" algn="ctr"/>
              <a:r>
                <a:rPr lang="en-US" sz="1600" dirty="0">
                  <a:cs typeface="Calibri"/>
                </a:rPr>
                <a:t>viruses with </a:t>
              </a:r>
            </a:p>
            <a:p>
              <a:pPr marL="12700" algn="ctr"/>
              <a:r>
                <a:rPr lang="en-US" sz="1600" dirty="0">
                  <a:cs typeface="Calibri"/>
                </a:rPr>
                <a:t>NA sequences </a:t>
              </a:r>
            </a:p>
            <a:p>
              <a:pPr marL="12700" algn="ctr"/>
              <a:r>
                <a:rPr lang="en-US" sz="1600" b="1" dirty="0">
                  <a:cs typeface="Calibri"/>
                </a:rPr>
                <a:t>NOT analyzed by WHO CC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36D7A9B-D9D5-40B9-B149-812450694935}"/>
                </a:ext>
              </a:extLst>
            </p:cNvPr>
            <p:cNvSpPr txBox="1"/>
            <p:nvPr/>
          </p:nvSpPr>
          <p:spPr>
            <a:xfrm>
              <a:off x="5832435" y="2386605"/>
              <a:ext cx="1873662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2700" algn="ctr"/>
              <a:r>
                <a:rPr lang="en-US" dirty="0">
                  <a:latin typeface="Calibri" panose="020F0502020204030204" pitchFamily="34" charset="0"/>
                </a:rPr>
                <a:t>n</a:t>
              </a:r>
              <a:r>
                <a:rPr lang="en-US" i="0" u="none" strike="noStrike" dirty="0">
                  <a:effectLst/>
                  <a:latin typeface="Calibri" panose="020F0502020204030204" pitchFamily="34" charset="0"/>
                </a:rPr>
                <a:t>=</a:t>
              </a:r>
              <a:r>
                <a:rPr lang="en-US" b="1" dirty="0">
                  <a:latin typeface="Calibri" panose="020F0502020204030204" pitchFamily="34" charset="0"/>
                </a:rPr>
                <a:t>5729</a:t>
              </a:r>
              <a:endParaRPr lang="en-US" b="1" i="0" u="none" strike="noStrike" dirty="0">
                <a:effectLst/>
                <a:latin typeface="Calibri" panose="020F0502020204030204" pitchFamily="34" charset="0"/>
              </a:endParaRPr>
            </a:p>
            <a:p>
              <a:pPr marL="12700" algn="ctr"/>
              <a:r>
                <a:rPr lang="en-US" sz="1400" dirty="0">
                  <a:cs typeface="Calibri"/>
                </a:rPr>
                <a:t>viruses pre-screened by Atlanta CC</a:t>
              </a:r>
            </a:p>
            <a:p>
              <a:pPr marL="12700" algn="ctr"/>
              <a:r>
                <a:rPr lang="en-US" sz="1400" b="1" dirty="0">
                  <a:cs typeface="Calibri"/>
                </a:rPr>
                <a:t>NO RI/HRI </a:t>
              </a:r>
              <a:r>
                <a:rPr lang="en-US" sz="1400" dirty="0">
                  <a:cs typeface="Calibri"/>
                </a:rPr>
                <a:t>markers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11CCB7A8-6FA5-4C5E-9C92-7E4D6564F3DF}"/>
                </a:ext>
              </a:extLst>
            </p:cNvPr>
            <p:cNvCxnSpPr/>
            <p:nvPr/>
          </p:nvCxnSpPr>
          <p:spPr>
            <a:xfrm flipV="1">
              <a:off x="5271887" y="2290354"/>
              <a:ext cx="472254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12975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2</TotalTime>
  <Words>241</Words>
  <Application>Microsoft Office PowerPoint</Application>
  <PresentationFormat>Widescreen</PresentationFormat>
  <Paragraphs>6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oinformatic analysis for Global Updates: Challenges</dc:title>
  <dc:creator>CDC</dc:creator>
  <cp:lastModifiedBy>Govorkova, Elena</cp:lastModifiedBy>
  <cp:revision>98</cp:revision>
  <dcterms:created xsi:type="dcterms:W3CDTF">2021-11-02T18:39:43Z</dcterms:created>
  <dcterms:modified xsi:type="dcterms:W3CDTF">2022-02-24T20:35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1-11-02T18:41:06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e244ac99-573b-455c-b0af-c25bd45a28c1</vt:lpwstr>
  </property>
  <property fmtid="{D5CDD505-2E9C-101B-9397-08002B2CF9AE}" pid="8" name="MSIP_Label_7b94a7b8-f06c-4dfe-bdcc-9b548fd58c31_ContentBits">
    <vt:lpwstr>0</vt:lpwstr>
  </property>
</Properties>
</file>